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7" r:id="rId2"/>
    <p:sldId id="259" r:id="rId3"/>
    <p:sldId id="268" r:id="rId4"/>
    <p:sldId id="265" r:id="rId5"/>
    <p:sldId id="267" r:id="rId6"/>
    <p:sldId id="264" r:id="rId7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3AEEA6-7BC3-234E-985F-338BB0878DA6}" v="1" dt="2024-07-30T12:15:47.99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031"/>
    <p:restoredTop sz="93750"/>
  </p:normalViewPr>
  <p:slideViewPr>
    <p:cSldViewPr snapToGrid="0">
      <p:cViewPr>
        <p:scale>
          <a:sx n="148" d="100"/>
          <a:sy n="148" d="100"/>
        </p:scale>
        <p:origin x="1720" y="-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n Zhao" userId="3b5aa489-47ea-468b-84f4-bfcef63c3ea6" providerId="ADAL" clId="{CF54C041-53B9-5E4A-AEFB-81688426B434}"/>
    <pc:docChg chg="undo redo custSel addSld delSld modSld sldOrd">
      <pc:chgData name="Yan Zhao" userId="3b5aa489-47ea-468b-84f4-bfcef63c3ea6" providerId="ADAL" clId="{CF54C041-53B9-5E4A-AEFB-81688426B434}" dt="2024-05-23T08:47:22.052" v="511" actId="2696"/>
      <pc:docMkLst>
        <pc:docMk/>
      </pc:docMkLst>
      <pc:sldChg chg="addSp delSp modSp mod">
        <pc:chgData name="Yan Zhao" userId="3b5aa489-47ea-468b-84f4-bfcef63c3ea6" providerId="ADAL" clId="{CF54C041-53B9-5E4A-AEFB-81688426B434}" dt="2024-05-16T19:32:42.016" v="456" actId="1076"/>
        <pc:sldMkLst>
          <pc:docMk/>
          <pc:sldMk cId="1116375164" sldId="257"/>
        </pc:sldMkLst>
        <pc:spChg chg="add del mod">
          <ac:chgData name="Yan Zhao" userId="3b5aa489-47ea-468b-84f4-bfcef63c3ea6" providerId="ADAL" clId="{CF54C041-53B9-5E4A-AEFB-81688426B434}" dt="2024-05-16T12:46:57.591" v="303" actId="478"/>
          <ac:spMkLst>
            <pc:docMk/>
            <pc:sldMk cId="1116375164" sldId="257"/>
            <ac:spMk id="3" creationId="{3F5C4E16-B290-2958-566C-4BE60A01EA75}"/>
          </ac:spMkLst>
        </pc:spChg>
        <pc:spChg chg="add mod">
          <ac:chgData name="Yan Zhao" userId="3b5aa489-47ea-468b-84f4-bfcef63c3ea6" providerId="ADAL" clId="{CF54C041-53B9-5E4A-AEFB-81688426B434}" dt="2024-05-16T12:48:36.242" v="304" actId="113"/>
          <ac:spMkLst>
            <pc:docMk/>
            <pc:sldMk cId="1116375164" sldId="257"/>
            <ac:spMk id="5" creationId="{E1C42691-B67D-7CC6-6377-A485AF292C47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6" creationId="{B2BE10A7-EE63-D322-0460-5C7377A860B2}"/>
          </ac:spMkLst>
        </pc:spChg>
        <pc:spChg chg="add mod">
          <ac:chgData name="Yan Zhao" userId="3b5aa489-47ea-468b-84f4-bfcef63c3ea6" providerId="ADAL" clId="{CF54C041-53B9-5E4A-AEFB-81688426B434}" dt="2024-05-16T12:53:02.964" v="350" actId="1076"/>
          <ac:spMkLst>
            <pc:docMk/>
            <pc:sldMk cId="1116375164" sldId="257"/>
            <ac:spMk id="6" creationId="{D3E48D0A-FD4E-662D-67D6-C5FD5C68A026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7" creationId="{B2F18DD7-7AFF-072F-5510-CDDCE89B89C0}"/>
          </ac:spMkLst>
        </pc:spChg>
        <pc:spChg chg="add del mod">
          <ac:chgData name="Yan Zhao" userId="3b5aa489-47ea-468b-84f4-bfcef63c3ea6" providerId="ADAL" clId="{CF54C041-53B9-5E4A-AEFB-81688426B434}" dt="2024-05-16T12:52:58.879" v="348" actId="478"/>
          <ac:spMkLst>
            <pc:docMk/>
            <pc:sldMk cId="1116375164" sldId="257"/>
            <ac:spMk id="7" creationId="{D65639CD-68D6-B87E-65F5-1410C5863D1C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8" creationId="{3ACD6DEE-B75F-7960-9A8A-707EEC906897}"/>
          </ac:spMkLst>
        </pc:spChg>
        <pc:spChg chg="add mod">
          <ac:chgData name="Yan Zhao" userId="3b5aa489-47ea-468b-84f4-bfcef63c3ea6" providerId="ADAL" clId="{CF54C041-53B9-5E4A-AEFB-81688426B434}" dt="2024-05-16T19:32:42.016" v="456" actId="1076"/>
          <ac:spMkLst>
            <pc:docMk/>
            <pc:sldMk cId="1116375164" sldId="257"/>
            <ac:spMk id="8" creationId="{71F6DD1A-182F-7ABC-E023-520C2CC06034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9" creationId="{D273D85B-07A6-93F2-9FC0-23698D639A02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10" creationId="{4871FD31-B48A-D36E-CCC3-1B1D08D6610F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11" creationId="{54C99B38-BA73-E173-DF7E-BB803C34AD61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12" creationId="{1A2339F8-4F19-F67E-A4D3-66D3E62E580E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15" creationId="{56FA6B7B-70CF-56EF-7BDB-EFF4FA5EB866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16" creationId="{8CC3582D-BF9B-08CE-D137-A8385E5C1815}"/>
          </ac:spMkLst>
        </pc:spChg>
        <pc:spChg chg="add del mod">
          <ac:chgData name="Yan Zhao" userId="3b5aa489-47ea-468b-84f4-bfcef63c3ea6" providerId="ADAL" clId="{CF54C041-53B9-5E4A-AEFB-81688426B434}" dt="2024-05-13T15:07:59.999" v="59" actId="478"/>
          <ac:spMkLst>
            <pc:docMk/>
            <pc:sldMk cId="1116375164" sldId="257"/>
            <ac:spMk id="21" creationId="{06355CCC-26FB-52B4-219F-0D67D0823283}"/>
          </ac:spMkLst>
        </pc:spChg>
        <pc:spChg chg="add del mod">
          <ac:chgData name="Yan Zhao" userId="3b5aa489-47ea-468b-84f4-bfcef63c3ea6" providerId="ADAL" clId="{CF54C041-53B9-5E4A-AEFB-81688426B434}" dt="2024-05-16T11:15:32.358" v="230" actId="478"/>
          <ac:spMkLst>
            <pc:docMk/>
            <pc:sldMk cId="1116375164" sldId="257"/>
            <ac:spMk id="32" creationId="{42A04FE5-67D4-9155-4E39-85A0E37F8D88}"/>
          </ac:spMkLst>
        </pc:spChg>
        <pc:spChg chg="add del mod">
          <ac:chgData name="Yan Zhao" userId="3b5aa489-47ea-468b-84f4-bfcef63c3ea6" providerId="ADAL" clId="{CF54C041-53B9-5E4A-AEFB-81688426B434}" dt="2024-05-16T11:15:32.358" v="230" actId="478"/>
          <ac:spMkLst>
            <pc:docMk/>
            <pc:sldMk cId="1116375164" sldId="257"/>
            <ac:spMk id="35" creationId="{77B0845A-F697-1B6B-8533-74B41A89BE76}"/>
          </ac:spMkLst>
        </pc:spChg>
        <pc:spChg chg="add del mod">
          <ac:chgData name="Yan Zhao" userId="3b5aa489-47ea-468b-84f4-bfcef63c3ea6" providerId="ADAL" clId="{CF54C041-53B9-5E4A-AEFB-81688426B434}" dt="2024-05-16T11:15:32.358" v="230" actId="478"/>
          <ac:spMkLst>
            <pc:docMk/>
            <pc:sldMk cId="1116375164" sldId="257"/>
            <ac:spMk id="36" creationId="{866D4B15-6247-8F47-0667-F354A1D49503}"/>
          </ac:spMkLst>
        </pc:spChg>
        <pc:spChg chg="add del mod">
          <ac:chgData name="Yan Zhao" userId="3b5aa489-47ea-468b-84f4-bfcef63c3ea6" providerId="ADAL" clId="{CF54C041-53B9-5E4A-AEFB-81688426B434}" dt="2024-05-16T11:15:32.358" v="230" actId="478"/>
          <ac:spMkLst>
            <pc:docMk/>
            <pc:sldMk cId="1116375164" sldId="257"/>
            <ac:spMk id="37" creationId="{318E38D9-76FC-8FA6-8B1B-C4C070B7B8D2}"/>
          </ac:spMkLst>
        </pc:spChg>
        <pc:picChg chg="add del mod">
          <ac:chgData name="Yan Zhao" userId="3b5aa489-47ea-468b-84f4-bfcef63c3ea6" providerId="ADAL" clId="{CF54C041-53B9-5E4A-AEFB-81688426B434}" dt="2024-05-16T19:30:58.391" v="430" actId="478"/>
          <ac:picMkLst>
            <pc:docMk/>
            <pc:sldMk cId="1116375164" sldId="257"/>
            <ac:picMk id="2" creationId="{D29C52E1-A48E-7E19-BEF8-CB14804C402D}"/>
          </ac:picMkLst>
        </pc:picChg>
        <pc:picChg chg="add del mod">
          <ac:chgData name="Yan Zhao" userId="3b5aa489-47ea-468b-84f4-bfcef63c3ea6" providerId="ADAL" clId="{CF54C041-53B9-5E4A-AEFB-81688426B434}" dt="2024-05-13T15:33:46.441" v="171" actId="478"/>
          <ac:picMkLst>
            <pc:docMk/>
            <pc:sldMk cId="1116375164" sldId="257"/>
            <ac:picMk id="3" creationId="{76B70853-138B-E35E-4069-0556D39D6D2A}"/>
          </ac:picMkLst>
        </pc:picChg>
        <pc:picChg chg="add del mod">
          <ac:chgData name="Yan Zhao" userId="3b5aa489-47ea-468b-84f4-bfcef63c3ea6" providerId="ADAL" clId="{CF54C041-53B9-5E4A-AEFB-81688426B434}" dt="2024-05-16T12:45:35.980" v="300" actId="478"/>
          <ac:picMkLst>
            <pc:docMk/>
            <pc:sldMk cId="1116375164" sldId="257"/>
            <ac:picMk id="4" creationId="{1F9C078F-458D-6508-D3DF-9D74A927A5D3}"/>
          </ac:picMkLst>
        </pc:picChg>
        <pc:picChg chg="add mod">
          <ac:chgData name="Yan Zhao" userId="3b5aa489-47ea-468b-84f4-bfcef63c3ea6" providerId="ADAL" clId="{CF54C041-53B9-5E4A-AEFB-81688426B434}" dt="2024-05-16T19:32:13.335" v="450" actId="1076"/>
          <ac:picMkLst>
            <pc:docMk/>
            <pc:sldMk cId="1116375164" sldId="257"/>
            <ac:picMk id="4" creationId="{67B7B23D-B742-FAAC-A8FA-C0ADB3B65767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5" creationId="{63E1FB20-F5D6-8925-E6B2-0D6224CA5DFF}"/>
          </ac:picMkLst>
        </pc:picChg>
        <pc:picChg chg="add mod">
          <ac:chgData name="Yan Zhao" userId="3b5aa489-47ea-468b-84f4-bfcef63c3ea6" providerId="ADAL" clId="{CF54C041-53B9-5E4A-AEFB-81688426B434}" dt="2024-05-16T19:32:20.030" v="454" actId="1076"/>
          <ac:picMkLst>
            <pc:docMk/>
            <pc:sldMk cId="1116375164" sldId="257"/>
            <ac:picMk id="9" creationId="{32A4A76E-4FA9-7085-4689-ECA5B4AE8882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13" creationId="{92231E8E-9F96-D8DD-2A71-31B8878BD0B4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14" creationId="{A7D55580-2C4B-2A00-D850-D8D85A9C5BF0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17" creationId="{C00B4836-8609-7093-3B06-535900570539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18" creationId="{2B8C9643-CC44-DEFA-EE17-0FAAFC36AD2F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19" creationId="{E1091D42-506E-EFA5-E1F2-EF22404295D9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20" creationId="{4FF1164B-3E82-685C-0CBD-24EF21EAD5A0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22" creationId="{1C8C08D4-4013-02AD-B735-523C2A3CF46E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23" creationId="{CCC8CB1A-8F25-EB1F-7033-D633AD2FF26A}"/>
          </ac:picMkLst>
        </pc:picChg>
        <pc:picChg chg="add del mod">
          <ac:chgData name="Yan Zhao" userId="3b5aa489-47ea-468b-84f4-bfcef63c3ea6" providerId="ADAL" clId="{CF54C041-53B9-5E4A-AEFB-81688426B434}" dt="2024-05-13T15:07:59.999" v="59" actId="478"/>
          <ac:picMkLst>
            <pc:docMk/>
            <pc:sldMk cId="1116375164" sldId="257"/>
            <ac:picMk id="24" creationId="{200133F9-12F2-854B-9DC5-60DDBAA9EAB4}"/>
          </ac:picMkLst>
        </pc:picChg>
        <pc:picChg chg="add del mod">
          <ac:chgData name="Yan Zhao" userId="3b5aa489-47ea-468b-84f4-bfcef63c3ea6" providerId="ADAL" clId="{CF54C041-53B9-5E4A-AEFB-81688426B434}" dt="2024-05-16T19:31:19.529" v="441" actId="478"/>
          <ac:picMkLst>
            <pc:docMk/>
            <pc:sldMk cId="1116375164" sldId="257"/>
            <ac:picMk id="25" creationId="{C8852E12-F4CC-1785-32C8-005A4888C7F7}"/>
          </ac:picMkLst>
        </pc:picChg>
        <pc:picChg chg="add mod">
          <ac:chgData name="Yan Zhao" userId="3b5aa489-47ea-468b-84f4-bfcef63c3ea6" providerId="ADAL" clId="{CF54C041-53B9-5E4A-AEFB-81688426B434}" dt="2024-05-16T19:32:22.392" v="455" actId="1076"/>
          <ac:picMkLst>
            <pc:docMk/>
            <pc:sldMk cId="1116375164" sldId="257"/>
            <ac:picMk id="27" creationId="{04297B1E-CE25-CA3E-C6DD-954B1B5F7116}"/>
          </ac:picMkLst>
        </pc:picChg>
        <pc:picChg chg="add del mod">
          <ac:chgData name="Yan Zhao" userId="3b5aa489-47ea-468b-84f4-bfcef63c3ea6" providerId="ADAL" clId="{CF54C041-53B9-5E4A-AEFB-81688426B434}" dt="2024-05-13T15:31:33.200" v="154" actId="478"/>
          <ac:picMkLst>
            <pc:docMk/>
            <pc:sldMk cId="1116375164" sldId="257"/>
            <ac:picMk id="28" creationId="{564AA0C0-94CA-E711-8C8A-1CD626CDF270}"/>
          </ac:picMkLst>
        </pc:picChg>
        <pc:picChg chg="add del mod">
          <ac:chgData name="Yan Zhao" userId="3b5aa489-47ea-468b-84f4-bfcef63c3ea6" providerId="ADAL" clId="{CF54C041-53B9-5E4A-AEFB-81688426B434}" dt="2024-05-13T15:31:33.200" v="154" actId="478"/>
          <ac:picMkLst>
            <pc:docMk/>
            <pc:sldMk cId="1116375164" sldId="257"/>
            <ac:picMk id="29" creationId="{F9B13559-B1F6-7C40-96FB-4D5BBA1EF4C8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0" creationId="{B730FC32-DFBB-0E0D-C476-21ED41272EB2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1" creationId="{DD248B93-365C-9C17-D5FA-8435D63B2ACC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3" creationId="{28B0D1D9-7D34-2B3B-97B0-1EF37D605859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4" creationId="{7A588ACA-765C-E8B1-016C-7065BBDB18AD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8" creationId="{0E7BA2FE-56A4-768A-C9C9-379B5EB2D930}"/>
          </ac:picMkLst>
        </pc:picChg>
        <pc:picChg chg="add del mod">
          <ac:chgData name="Yan Zhao" userId="3b5aa489-47ea-468b-84f4-bfcef63c3ea6" providerId="ADAL" clId="{CF54C041-53B9-5E4A-AEFB-81688426B434}" dt="2024-05-16T11:15:32.358" v="230" actId="478"/>
          <ac:picMkLst>
            <pc:docMk/>
            <pc:sldMk cId="1116375164" sldId="257"/>
            <ac:picMk id="39" creationId="{3052AD49-632B-B923-9368-A429A66E4102}"/>
          </ac:picMkLst>
        </pc:picChg>
        <pc:picChg chg="add del mod">
          <ac:chgData name="Yan Zhao" userId="3b5aa489-47ea-468b-84f4-bfcef63c3ea6" providerId="ADAL" clId="{CF54C041-53B9-5E4A-AEFB-81688426B434}" dt="2024-05-13T15:33:24.111" v="168"/>
          <ac:picMkLst>
            <pc:docMk/>
            <pc:sldMk cId="1116375164" sldId="257"/>
            <ac:picMk id="40" creationId="{1CCD124D-E20F-1608-9E94-36AFCB1E1662}"/>
          </ac:picMkLst>
        </pc:picChg>
      </pc:sldChg>
      <pc:sldChg chg="addSp delSp modSp del mod">
        <pc:chgData name="Yan Zhao" userId="3b5aa489-47ea-468b-84f4-bfcef63c3ea6" providerId="ADAL" clId="{CF54C041-53B9-5E4A-AEFB-81688426B434}" dt="2024-05-13T15:32:01.516" v="160" actId="2696"/>
        <pc:sldMkLst>
          <pc:docMk/>
          <pc:sldMk cId="1817247973" sldId="258"/>
        </pc:sldMkLst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4" creationId="{5C78B728-26C0-6EDF-440D-2B5958EEF9AF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7" creationId="{27113E9E-3FF1-4A29-69D2-8E884CE2C067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8" creationId="{15BEDF92-545B-4AE6-E94B-B32176BEF93B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9" creationId="{21D80BFA-7391-062E-9F57-D2753BF247B1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10" creationId="{38ECB1F7-E328-E81F-E0B2-86C769508FB9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11" creationId="{234E3E85-93C1-0182-5995-7833F9BAA765}"/>
          </ac:spMkLst>
        </pc:spChg>
        <pc:spChg chg="add del mod">
          <ac:chgData name="Yan Zhao" userId="3b5aa489-47ea-468b-84f4-bfcef63c3ea6" providerId="ADAL" clId="{CF54C041-53B9-5E4A-AEFB-81688426B434}" dt="2024-05-13T15:05:20.255" v="28"/>
          <ac:spMkLst>
            <pc:docMk/>
            <pc:sldMk cId="1817247973" sldId="258"/>
            <ac:spMk id="14" creationId="{04D07870-403B-7658-00A3-69DEAE705376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19" creationId="{A751DF00-0B7D-04AC-2CD9-A2D986F21526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2" creationId="{F4778E13-C294-CDDD-55E4-8D0193A66FF2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3" creationId="{2B9E5628-612E-E3BE-4E06-172B8CCC565F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4" creationId="{35AFE253-DF06-F358-75C4-3549E78F3F74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5" creationId="{ECCCCFD6-AE12-0D89-2FAC-30D2CB91CD35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6" creationId="{B4775117-AD25-3875-A126-17E2C13A6B33}"/>
          </ac:spMkLst>
        </pc:spChg>
        <pc:spChg chg="add del mod">
          <ac:chgData name="Yan Zhao" userId="3b5aa489-47ea-468b-84f4-bfcef63c3ea6" providerId="ADAL" clId="{CF54C041-53B9-5E4A-AEFB-81688426B434}" dt="2024-05-13T15:05:37.924" v="32"/>
          <ac:spMkLst>
            <pc:docMk/>
            <pc:sldMk cId="1817247973" sldId="258"/>
            <ac:spMk id="29" creationId="{EFE0FF19-6730-FAB1-232A-BB3DEC8EF3E5}"/>
          </ac:spMkLst>
        </pc:spChg>
        <pc:spChg chg="add del mod">
          <ac:chgData name="Yan Zhao" userId="3b5aa489-47ea-468b-84f4-bfcef63c3ea6" providerId="ADAL" clId="{CF54C041-53B9-5E4A-AEFB-81688426B434}" dt="2024-05-13T15:06:00.827" v="36"/>
          <ac:spMkLst>
            <pc:docMk/>
            <pc:sldMk cId="1817247973" sldId="258"/>
            <ac:spMk id="34" creationId="{303FB8A8-F161-01FC-FD73-AF02AE12D198}"/>
          </ac:spMkLst>
        </pc:spChg>
        <pc:spChg chg="add del mod">
          <ac:chgData name="Yan Zhao" userId="3b5aa489-47ea-468b-84f4-bfcef63c3ea6" providerId="ADAL" clId="{CF54C041-53B9-5E4A-AEFB-81688426B434}" dt="2024-05-13T15:06:00.827" v="36"/>
          <ac:spMkLst>
            <pc:docMk/>
            <pc:sldMk cId="1817247973" sldId="258"/>
            <ac:spMk id="37" creationId="{B04FCBB1-E862-E344-2630-6B86D5D9AA84}"/>
          </ac:spMkLst>
        </pc:spChg>
        <pc:spChg chg="add del mod">
          <ac:chgData name="Yan Zhao" userId="3b5aa489-47ea-468b-84f4-bfcef63c3ea6" providerId="ADAL" clId="{CF54C041-53B9-5E4A-AEFB-81688426B434}" dt="2024-05-13T15:06:00.827" v="36"/>
          <ac:spMkLst>
            <pc:docMk/>
            <pc:sldMk cId="1817247973" sldId="258"/>
            <ac:spMk id="38" creationId="{1112AC8D-0A70-ACCF-F9B8-5E86BC2D4D7D}"/>
          </ac:spMkLst>
        </pc:spChg>
        <pc:spChg chg="add del mod">
          <ac:chgData name="Yan Zhao" userId="3b5aa489-47ea-468b-84f4-bfcef63c3ea6" providerId="ADAL" clId="{CF54C041-53B9-5E4A-AEFB-81688426B434}" dt="2024-05-13T15:06:00.827" v="36"/>
          <ac:spMkLst>
            <pc:docMk/>
            <pc:sldMk cId="1817247973" sldId="258"/>
            <ac:spMk id="39" creationId="{B41A0B54-D632-29E7-8532-4253C9532DE1}"/>
          </ac:spMkLst>
        </pc:spChg>
        <pc:spChg chg="add del mod">
          <ac:chgData name="Yan Zhao" userId="3b5aa489-47ea-468b-84f4-bfcef63c3ea6" providerId="ADAL" clId="{CF54C041-53B9-5E4A-AEFB-81688426B434}" dt="2024-05-13T15:06:00.827" v="36"/>
          <ac:spMkLst>
            <pc:docMk/>
            <pc:sldMk cId="1817247973" sldId="258"/>
            <ac:spMk id="40" creationId="{B3688996-7A8D-2D54-5998-93AB9348A7D2}"/>
          </ac:spMkLst>
        </pc:spChg>
        <pc:spChg chg="add del mod">
          <ac:chgData name="Yan Zhao" userId="3b5aa489-47ea-468b-84f4-bfcef63c3ea6" providerId="ADAL" clId="{CF54C041-53B9-5E4A-AEFB-81688426B434}" dt="2024-05-13T15:31:05.373" v="150" actId="21"/>
          <ac:spMkLst>
            <pc:docMk/>
            <pc:sldMk cId="1817247973" sldId="258"/>
            <ac:spMk id="47" creationId="{7AF23C32-51A1-5D97-45FD-EDAEABFFC8F1}"/>
          </ac:spMkLst>
        </pc:spChg>
        <pc:spChg chg="add del mod">
          <ac:chgData name="Yan Zhao" userId="3b5aa489-47ea-468b-84f4-bfcef63c3ea6" providerId="ADAL" clId="{CF54C041-53B9-5E4A-AEFB-81688426B434}" dt="2024-05-13T15:31:05.373" v="150" actId="21"/>
          <ac:spMkLst>
            <pc:docMk/>
            <pc:sldMk cId="1817247973" sldId="258"/>
            <ac:spMk id="50" creationId="{9F9526C3-A1BF-80DA-105B-B84BD3027F96}"/>
          </ac:spMkLst>
        </pc:spChg>
        <pc:spChg chg="add del mod">
          <ac:chgData name="Yan Zhao" userId="3b5aa489-47ea-468b-84f4-bfcef63c3ea6" providerId="ADAL" clId="{CF54C041-53B9-5E4A-AEFB-81688426B434}" dt="2024-05-13T15:31:05.373" v="150" actId="21"/>
          <ac:spMkLst>
            <pc:docMk/>
            <pc:sldMk cId="1817247973" sldId="258"/>
            <ac:spMk id="51" creationId="{A250AC7F-D800-487F-C27E-D66F14838902}"/>
          </ac:spMkLst>
        </pc:spChg>
        <pc:spChg chg="add del mod">
          <ac:chgData name="Yan Zhao" userId="3b5aa489-47ea-468b-84f4-bfcef63c3ea6" providerId="ADAL" clId="{CF54C041-53B9-5E4A-AEFB-81688426B434}" dt="2024-05-13T15:31:05.373" v="150" actId="21"/>
          <ac:spMkLst>
            <pc:docMk/>
            <pc:sldMk cId="1817247973" sldId="258"/>
            <ac:spMk id="52" creationId="{A3ABF55E-040B-744A-8059-FF8C145490CB}"/>
          </ac:spMkLst>
        </pc:sp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2" creationId="{0AD361D0-F7DD-499F-A501-3CF09FD2A477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3" creationId="{F444FB27-B997-0353-CBBD-4636CA33B25D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5" creationId="{78EF442A-C12C-84B6-CE6A-973DEB1C3E63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6" creationId="{05AF0E6B-F14F-5E5A-5BFD-19D4C2402AF8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12" creationId="{09A7EE8F-8326-2283-6B29-03C4945403D7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13" creationId="{C6457A38-C560-0AB3-BA6F-DC2B87E13F66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15" creationId="{E1B586A9-8112-7045-AF09-54942A0A9AAB}"/>
          </ac:picMkLst>
        </pc:picChg>
        <pc:picChg chg="add del mod">
          <ac:chgData name="Yan Zhao" userId="3b5aa489-47ea-468b-84f4-bfcef63c3ea6" providerId="ADAL" clId="{CF54C041-53B9-5E4A-AEFB-81688426B434}" dt="2024-05-13T15:05:20.255" v="28"/>
          <ac:picMkLst>
            <pc:docMk/>
            <pc:sldMk cId="1817247973" sldId="258"/>
            <ac:picMk id="16" creationId="{AE04CA85-1251-3EC9-FC75-7CFDFCA7CCB1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17" creationId="{2297482F-76D8-9E98-EAC1-44C90E19BA18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18" creationId="{5D384D93-1EFE-A626-959E-E63A784B46CE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20" creationId="{B8402CE6-5C76-AF6D-CAC0-43D4D88E0EB3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21" creationId="{C78C2F94-BB59-424E-0A1A-D91616571B87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27" creationId="{0B147618-DB32-3988-C587-17D934770E18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28" creationId="{5D31B404-8722-798B-8E69-2E48D6DC9A76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30" creationId="{EBAB1E6E-5749-FC18-FBAC-7F924506B4D6}"/>
          </ac:picMkLst>
        </pc:picChg>
        <pc:picChg chg="add del mod">
          <ac:chgData name="Yan Zhao" userId="3b5aa489-47ea-468b-84f4-bfcef63c3ea6" providerId="ADAL" clId="{CF54C041-53B9-5E4A-AEFB-81688426B434}" dt="2024-05-13T15:05:37.924" v="32"/>
          <ac:picMkLst>
            <pc:docMk/>
            <pc:sldMk cId="1817247973" sldId="258"/>
            <ac:picMk id="31" creationId="{DF752509-7FA7-BA69-07D3-B2C16B85E28B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32" creationId="{5AAB8282-2988-D13B-CB44-D92F955896B7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33" creationId="{3D822F9E-B649-A95A-A8E7-4F545CDE2562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35" creationId="{1FFD417C-C694-EA71-7707-F311E4E2AAB2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36" creationId="{AC10D573-016B-9D6D-3ADC-DA8BD1D42603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41" creationId="{FCC4D206-1728-185B-CDC6-B42562D7C843}"/>
          </ac:picMkLst>
        </pc:picChg>
        <pc:picChg chg="add del mod">
          <ac:chgData name="Yan Zhao" userId="3b5aa489-47ea-468b-84f4-bfcef63c3ea6" providerId="ADAL" clId="{CF54C041-53B9-5E4A-AEFB-81688426B434}" dt="2024-05-13T15:06:00.827" v="36"/>
          <ac:picMkLst>
            <pc:docMk/>
            <pc:sldMk cId="1817247973" sldId="258"/>
            <ac:picMk id="42" creationId="{E15AA0B5-9CB8-D56E-ACEC-B8E2B1C88808}"/>
          </ac:picMkLst>
        </pc:picChg>
        <pc:picChg chg="add del mod">
          <ac:chgData name="Yan Zhao" userId="3b5aa489-47ea-468b-84f4-bfcef63c3ea6" providerId="ADAL" clId="{CF54C041-53B9-5E4A-AEFB-81688426B434}" dt="2024-05-13T15:30:39.890" v="141" actId="21"/>
          <ac:picMkLst>
            <pc:docMk/>
            <pc:sldMk cId="1817247973" sldId="258"/>
            <ac:picMk id="43" creationId="{390BD70E-5095-12A3-0ADC-D8197F48DFDC}"/>
          </ac:picMkLst>
        </pc:picChg>
        <pc:picChg chg="add del mod">
          <ac:chgData name="Yan Zhao" userId="3b5aa489-47ea-468b-84f4-bfcef63c3ea6" providerId="ADAL" clId="{CF54C041-53B9-5E4A-AEFB-81688426B434}" dt="2024-05-13T15:30:39.890" v="141" actId="21"/>
          <ac:picMkLst>
            <pc:docMk/>
            <pc:sldMk cId="1817247973" sldId="258"/>
            <ac:picMk id="44" creationId="{1E55D77F-7745-7527-47E8-D014255FC1DF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45" creationId="{B8458C4A-6F19-FB4B-A85F-7D9BB4AB313D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46" creationId="{A7BF3204-C100-EA90-F04A-B4BEB88F4ED7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48" creationId="{B1353C01-4D9B-4A98-5EF9-18BFCCB59AD7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49" creationId="{12945B71-9C9D-42C8-347A-B1B0B9A02744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53" creationId="{A791FDDF-1DE6-EA73-CB2D-BD83752C43EB}"/>
          </ac:picMkLst>
        </pc:picChg>
        <pc:picChg chg="add del mod">
          <ac:chgData name="Yan Zhao" userId="3b5aa489-47ea-468b-84f4-bfcef63c3ea6" providerId="ADAL" clId="{CF54C041-53B9-5E4A-AEFB-81688426B434}" dt="2024-05-13T15:31:05.373" v="150" actId="21"/>
          <ac:picMkLst>
            <pc:docMk/>
            <pc:sldMk cId="1817247973" sldId="258"/>
            <ac:picMk id="54" creationId="{DDE1582B-462F-1216-0B5E-8CCED7F49E26}"/>
          </ac:picMkLst>
        </pc:picChg>
      </pc:sldChg>
      <pc:sldChg chg="addSp delSp modSp new mod">
        <pc:chgData name="Yan Zhao" userId="3b5aa489-47ea-468b-84f4-bfcef63c3ea6" providerId="ADAL" clId="{CF54C041-53B9-5E4A-AEFB-81688426B434}" dt="2024-05-16T12:48:45.550" v="308" actId="20577"/>
        <pc:sldMkLst>
          <pc:docMk/>
          <pc:sldMk cId="2903892845" sldId="259"/>
        </pc:sldMkLst>
        <pc:spChg chg="add mod">
          <ac:chgData name="Yan Zhao" userId="3b5aa489-47ea-468b-84f4-bfcef63c3ea6" providerId="ADAL" clId="{CF54C041-53B9-5E4A-AEFB-81688426B434}" dt="2024-05-16T12:48:45.550" v="308" actId="20577"/>
          <ac:spMkLst>
            <pc:docMk/>
            <pc:sldMk cId="2903892845" sldId="259"/>
            <ac:spMk id="3" creationId="{FFEF2F04-1357-A1AC-0112-067055DA1BAA}"/>
          </ac:spMkLst>
        </pc:spChg>
        <pc:picChg chg="add mod">
          <ac:chgData name="Yan Zhao" userId="3b5aa489-47ea-468b-84f4-bfcef63c3ea6" providerId="ADAL" clId="{CF54C041-53B9-5E4A-AEFB-81688426B434}" dt="2024-05-16T12:48:41.500" v="305" actId="1076"/>
          <ac:picMkLst>
            <pc:docMk/>
            <pc:sldMk cId="2903892845" sldId="259"/>
            <ac:picMk id="2" creationId="{9C498391-3A5F-8E6F-7A31-CC8DDCF7A062}"/>
          </ac:picMkLst>
        </pc:picChg>
        <pc:picChg chg="add del mod">
          <ac:chgData name="Yan Zhao" userId="3b5aa489-47ea-468b-84f4-bfcef63c3ea6" providerId="ADAL" clId="{CF54C041-53B9-5E4A-AEFB-81688426B434}" dt="2024-05-13T15:34:46.214" v="185" actId="478"/>
          <ac:picMkLst>
            <pc:docMk/>
            <pc:sldMk cId="2903892845" sldId="259"/>
            <ac:picMk id="3" creationId="{114BFD7C-F2EF-B721-0634-12F4D1DB90A7}"/>
          </ac:picMkLst>
        </pc:picChg>
        <pc:picChg chg="add del mod">
          <ac:chgData name="Yan Zhao" userId="3b5aa489-47ea-468b-84f4-bfcef63c3ea6" providerId="ADAL" clId="{CF54C041-53B9-5E4A-AEFB-81688426B434}" dt="2024-05-13T15:34:46.214" v="185" actId="478"/>
          <ac:picMkLst>
            <pc:docMk/>
            <pc:sldMk cId="2903892845" sldId="259"/>
            <ac:picMk id="4" creationId="{A78B2648-A0EC-35D4-6529-425B77D72542}"/>
          </ac:picMkLst>
        </pc:picChg>
        <pc:picChg chg="add del mod">
          <ac:chgData name="Yan Zhao" userId="3b5aa489-47ea-468b-84f4-bfcef63c3ea6" providerId="ADAL" clId="{CF54C041-53B9-5E4A-AEFB-81688426B434}" dt="2024-05-16T12:17:20.423" v="242" actId="21"/>
          <ac:picMkLst>
            <pc:docMk/>
            <pc:sldMk cId="2903892845" sldId="259"/>
            <ac:picMk id="5" creationId="{C69D74A3-6982-267A-9CB1-3BABC7BFA78E}"/>
          </ac:picMkLst>
        </pc:picChg>
        <pc:picChg chg="add del mod">
          <ac:chgData name="Yan Zhao" userId="3b5aa489-47ea-468b-84f4-bfcef63c3ea6" providerId="ADAL" clId="{CF54C041-53B9-5E4A-AEFB-81688426B434}" dt="2024-05-16T12:17:20.423" v="242" actId="21"/>
          <ac:picMkLst>
            <pc:docMk/>
            <pc:sldMk cId="2903892845" sldId="259"/>
            <ac:picMk id="6" creationId="{65245691-783D-9AA7-5F84-9BDECABDA8BB}"/>
          </ac:picMkLst>
        </pc:picChg>
      </pc:sldChg>
      <pc:sldChg chg="addSp delSp modSp new del mod">
        <pc:chgData name="Yan Zhao" userId="3b5aa489-47ea-468b-84f4-bfcef63c3ea6" providerId="ADAL" clId="{CF54C041-53B9-5E4A-AEFB-81688426B434}" dt="2024-05-13T15:32:03.615" v="161" actId="2696"/>
        <pc:sldMkLst>
          <pc:docMk/>
          <pc:sldMk cId="2464658849" sldId="260"/>
        </pc:sldMkLst>
        <pc:spChg chg="add del mod">
          <ac:chgData name="Yan Zhao" userId="3b5aa489-47ea-468b-84f4-bfcef63c3ea6" providerId="ADAL" clId="{CF54C041-53B9-5E4A-AEFB-81688426B434}" dt="2024-05-13T15:09:38.296" v="83" actId="478"/>
          <ac:spMkLst>
            <pc:docMk/>
            <pc:sldMk cId="2464658849" sldId="260"/>
            <ac:spMk id="4" creationId="{F8942C22-7E8A-A60C-C4F4-7A95538E2407}"/>
          </ac:spMkLst>
        </pc:spChg>
        <pc:spChg chg="add del mod">
          <ac:chgData name="Yan Zhao" userId="3b5aa489-47ea-468b-84f4-bfcef63c3ea6" providerId="ADAL" clId="{CF54C041-53B9-5E4A-AEFB-81688426B434}" dt="2024-05-13T15:09:38.296" v="83" actId="478"/>
          <ac:spMkLst>
            <pc:docMk/>
            <pc:sldMk cId="2464658849" sldId="260"/>
            <ac:spMk id="5" creationId="{D221519A-799F-05E1-C9AA-14ECB3C2B5CE}"/>
          </ac:spMkLst>
        </pc:spChg>
        <pc:picChg chg="add del mod">
          <ac:chgData name="Yan Zhao" userId="3b5aa489-47ea-468b-84f4-bfcef63c3ea6" providerId="ADAL" clId="{CF54C041-53B9-5E4A-AEFB-81688426B434}" dt="2024-05-13T15:31:56.039" v="157" actId="21"/>
          <ac:picMkLst>
            <pc:docMk/>
            <pc:sldMk cId="2464658849" sldId="260"/>
            <ac:picMk id="2" creationId="{719D6463-F100-A47B-89C2-D907D66BE99E}"/>
          </ac:picMkLst>
        </pc:picChg>
        <pc:picChg chg="add del mod">
          <ac:chgData name="Yan Zhao" userId="3b5aa489-47ea-468b-84f4-bfcef63c3ea6" providerId="ADAL" clId="{CF54C041-53B9-5E4A-AEFB-81688426B434}" dt="2024-05-13T15:31:56.039" v="157" actId="21"/>
          <ac:picMkLst>
            <pc:docMk/>
            <pc:sldMk cId="2464658849" sldId="260"/>
            <ac:picMk id="3" creationId="{6536F277-175D-2DA1-A538-3836971BBE5D}"/>
          </ac:picMkLst>
        </pc:picChg>
      </pc:sldChg>
      <pc:sldChg chg="addSp delSp modSp new del mod">
        <pc:chgData name="Yan Zhao" userId="3b5aa489-47ea-468b-84f4-bfcef63c3ea6" providerId="ADAL" clId="{CF54C041-53B9-5E4A-AEFB-81688426B434}" dt="2024-05-13T15:35:06.058" v="195" actId="2696"/>
        <pc:sldMkLst>
          <pc:docMk/>
          <pc:sldMk cId="3645621174" sldId="261"/>
        </pc:sldMkLst>
        <pc:spChg chg="add del mod">
          <ac:chgData name="Yan Zhao" userId="3b5aa489-47ea-468b-84f4-bfcef63c3ea6" providerId="ADAL" clId="{CF54C041-53B9-5E4A-AEFB-81688426B434}" dt="2024-05-13T15:11:18.070" v="91" actId="478"/>
          <ac:spMkLst>
            <pc:docMk/>
            <pc:sldMk cId="3645621174" sldId="261"/>
            <ac:spMk id="4" creationId="{141A4857-9BDC-DF41-1403-A37A6F24DED2}"/>
          </ac:spMkLst>
        </pc:spChg>
        <pc:spChg chg="add del mod">
          <ac:chgData name="Yan Zhao" userId="3b5aa489-47ea-468b-84f4-bfcef63c3ea6" providerId="ADAL" clId="{CF54C041-53B9-5E4A-AEFB-81688426B434}" dt="2024-05-13T15:11:18.070" v="91" actId="478"/>
          <ac:spMkLst>
            <pc:docMk/>
            <pc:sldMk cId="3645621174" sldId="261"/>
            <ac:spMk id="5" creationId="{C8EF37DE-244B-A9AC-48E6-2136E1C7D5CB}"/>
          </ac:spMkLst>
        </pc:spChg>
        <pc:picChg chg="add del mod">
          <ac:chgData name="Yan Zhao" userId="3b5aa489-47ea-468b-84f4-bfcef63c3ea6" providerId="ADAL" clId="{CF54C041-53B9-5E4A-AEFB-81688426B434}" dt="2024-05-13T15:34:50.008" v="186" actId="21"/>
          <ac:picMkLst>
            <pc:docMk/>
            <pc:sldMk cId="3645621174" sldId="261"/>
            <ac:picMk id="2" creationId="{B5891791-7308-C844-9386-9A98CDF46883}"/>
          </ac:picMkLst>
        </pc:picChg>
        <pc:picChg chg="add del mod">
          <ac:chgData name="Yan Zhao" userId="3b5aa489-47ea-468b-84f4-bfcef63c3ea6" providerId="ADAL" clId="{CF54C041-53B9-5E4A-AEFB-81688426B434}" dt="2024-05-13T15:34:50.008" v="186" actId="21"/>
          <ac:picMkLst>
            <pc:docMk/>
            <pc:sldMk cId="3645621174" sldId="261"/>
            <ac:picMk id="3" creationId="{BE78D7BC-4AE0-77F0-8B60-DF4EB69EADA7}"/>
          </ac:picMkLst>
        </pc:picChg>
      </pc:sldChg>
      <pc:sldChg chg="addSp delSp modSp new del mod">
        <pc:chgData name="Yan Zhao" userId="3b5aa489-47ea-468b-84f4-bfcef63c3ea6" providerId="ADAL" clId="{CF54C041-53B9-5E4A-AEFB-81688426B434}" dt="2024-05-13T15:35:06.900" v="196" actId="2696"/>
        <pc:sldMkLst>
          <pc:docMk/>
          <pc:sldMk cId="2420118661" sldId="262"/>
        </pc:sldMkLst>
        <pc:picChg chg="add del mod">
          <ac:chgData name="Yan Zhao" userId="3b5aa489-47ea-468b-84f4-bfcef63c3ea6" providerId="ADAL" clId="{CF54C041-53B9-5E4A-AEFB-81688426B434}" dt="2024-05-13T15:32:23.094" v="163" actId="21"/>
          <ac:picMkLst>
            <pc:docMk/>
            <pc:sldMk cId="2420118661" sldId="262"/>
            <ac:picMk id="2" creationId="{14B75C4A-8E5E-B658-7BC8-11B33BD43241}"/>
          </ac:picMkLst>
        </pc:picChg>
      </pc:sldChg>
      <pc:sldChg chg="addSp delSp modSp new del mod">
        <pc:chgData name="Yan Zhao" userId="3b5aa489-47ea-468b-84f4-bfcef63c3ea6" providerId="ADAL" clId="{CF54C041-53B9-5E4A-AEFB-81688426B434}" dt="2024-05-13T15:43:54.376" v="220" actId="2696"/>
        <pc:sldMkLst>
          <pc:docMk/>
          <pc:sldMk cId="1433213100" sldId="263"/>
        </pc:sldMkLst>
        <pc:picChg chg="add del mod">
          <ac:chgData name="Yan Zhao" userId="3b5aa489-47ea-468b-84f4-bfcef63c3ea6" providerId="ADAL" clId="{CF54C041-53B9-5E4A-AEFB-81688426B434}" dt="2024-05-13T15:43:49.921" v="217" actId="21"/>
          <ac:picMkLst>
            <pc:docMk/>
            <pc:sldMk cId="1433213100" sldId="263"/>
            <ac:picMk id="2" creationId="{56A6994D-53DF-B902-0014-F3CB5820CD57}"/>
          </ac:picMkLst>
        </pc:picChg>
        <pc:picChg chg="add del mod">
          <ac:chgData name="Yan Zhao" userId="3b5aa489-47ea-468b-84f4-bfcef63c3ea6" providerId="ADAL" clId="{CF54C041-53B9-5E4A-AEFB-81688426B434}" dt="2024-05-13T15:43:49.921" v="217" actId="21"/>
          <ac:picMkLst>
            <pc:docMk/>
            <pc:sldMk cId="1433213100" sldId="263"/>
            <ac:picMk id="3" creationId="{EF2F0A90-F854-3007-90E6-49D14B14DE7E}"/>
          </ac:picMkLst>
        </pc:picChg>
      </pc:sldChg>
      <pc:sldChg chg="addSp delSp modSp new mod ord">
        <pc:chgData name="Yan Zhao" userId="3b5aa489-47ea-468b-84f4-bfcef63c3ea6" providerId="ADAL" clId="{CF54C041-53B9-5E4A-AEFB-81688426B434}" dt="2024-05-19T09:57:18.522" v="506" actId="20577"/>
        <pc:sldMkLst>
          <pc:docMk/>
          <pc:sldMk cId="3351872524" sldId="264"/>
        </pc:sldMkLst>
        <pc:spChg chg="add mod">
          <ac:chgData name="Yan Zhao" userId="3b5aa489-47ea-468b-84f4-bfcef63c3ea6" providerId="ADAL" clId="{CF54C041-53B9-5E4A-AEFB-81688426B434}" dt="2024-05-16T12:59:09.177" v="419" actId="12788"/>
          <ac:spMkLst>
            <pc:docMk/>
            <pc:sldMk cId="3351872524" sldId="264"/>
            <ac:spMk id="3" creationId="{E34617F3-476A-1CFE-1990-16568920F6D8}"/>
          </ac:spMkLst>
        </pc:spChg>
        <pc:spChg chg="add mod">
          <ac:chgData name="Yan Zhao" userId="3b5aa489-47ea-468b-84f4-bfcef63c3ea6" providerId="ADAL" clId="{CF54C041-53B9-5E4A-AEFB-81688426B434}" dt="2024-05-16T12:59:09.177" v="419" actId="12788"/>
          <ac:spMkLst>
            <pc:docMk/>
            <pc:sldMk cId="3351872524" sldId="264"/>
            <ac:spMk id="4" creationId="{61906F06-18EB-5640-782C-D1BDC24CF039}"/>
          </ac:spMkLst>
        </pc:spChg>
        <pc:spChg chg="add del mod">
          <ac:chgData name="Yan Zhao" userId="3b5aa489-47ea-468b-84f4-bfcef63c3ea6" providerId="ADAL" clId="{CF54C041-53B9-5E4A-AEFB-81688426B434}" dt="2024-05-16T12:54:56.345" v="377" actId="478"/>
          <ac:spMkLst>
            <pc:docMk/>
            <pc:sldMk cId="3351872524" sldId="264"/>
            <ac:spMk id="6" creationId="{0F742152-6AEB-01F4-6CA2-056D62F57E59}"/>
          </ac:spMkLst>
        </pc:spChg>
        <pc:spChg chg="add del mod">
          <ac:chgData name="Yan Zhao" userId="3b5aa489-47ea-468b-84f4-bfcef63c3ea6" providerId="ADAL" clId="{CF54C041-53B9-5E4A-AEFB-81688426B434}" dt="2024-05-16T12:54:59.683" v="378" actId="478"/>
          <ac:spMkLst>
            <pc:docMk/>
            <pc:sldMk cId="3351872524" sldId="264"/>
            <ac:spMk id="8" creationId="{0F33FB1A-4BB4-124B-62FE-86C024E081B0}"/>
          </ac:spMkLst>
        </pc:spChg>
        <pc:spChg chg="add mod">
          <ac:chgData name="Yan Zhao" userId="3b5aa489-47ea-468b-84f4-bfcef63c3ea6" providerId="ADAL" clId="{CF54C041-53B9-5E4A-AEFB-81688426B434}" dt="2024-05-16T12:59:09.177" v="419" actId="12788"/>
          <ac:spMkLst>
            <pc:docMk/>
            <pc:sldMk cId="3351872524" sldId="264"/>
            <ac:spMk id="9" creationId="{92DFF016-C66A-DB72-DD2D-F45755C209CB}"/>
          </ac:spMkLst>
        </pc:spChg>
        <pc:spChg chg="add del mod">
          <ac:chgData name="Yan Zhao" userId="3b5aa489-47ea-468b-84f4-bfcef63c3ea6" providerId="ADAL" clId="{CF54C041-53B9-5E4A-AEFB-81688426B434}" dt="2024-05-16T12:54:56.345" v="377" actId="478"/>
          <ac:spMkLst>
            <pc:docMk/>
            <pc:sldMk cId="3351872524" sldId="264"/>
            <ac:spMk id="11" creationId="{575F8FC9-680E-638F-4F47-89F0387D3D03}"/>
          </ac:spMkLst>
        </pc:spChg>
        <pc:spChg chg="add del mod">
          <ac:chgData name="Yan Zhao" userId="3b5aa489-47ea-468b-84f4-bfcef63c3ea6" providerId="ADAL" clId="{CF54C041-53B9-5E4A-AEFB-81688426B434}" dt="2024-05-16T12:54:59.683" v="378" actId="478"/>
          <ac:spMkLst>
            <pc:docMk/>
            <pc:sldMk cId="3351872524" sldId="264"/>
            <ac:spMk id="13" creationId="{4111CCF9-8029-4BA6-ADE5-3D356762DB5E}"/>
          </ac:spMkLst>
        </pc:spChg>
        <pc:spChg chg="add mod">
          <ac:chgData name="Yan Zhao" userId="3b5aa489-47ea-468b-84f4-bfcef63c3ea6" providerId="ADAL" clId="{CF54C041-53B9-5E4A-AEFB-81688426B434}" dt="2024-05-16T12:59:19.886" v="420" actId="1076"/>
          <ac:spMkLst>
            <pc:docMk/>
            <pc:sldMk cId="3351872524" sldId="264"/>
            <ac:spMk id="15" creationId="{DADB8A5C-66A0-CDF8-227D-E8636C185137}"/>
          </ac:spMkLst>
        </pc:spChg>
        <pc:spChg chg="add del mod">
          <ac:chgData name="Yan Zhao" userId="3b5aa489-47ea-468b-84f4-bfcef63c3ea6" providerId="ADAL" clId="{CF54C041-53B9-5E4A-AEFB-81688426B434}" dt="2024-05-16T12:54:56.345" v="377" actId="478"/>
          <ac:spMkLst>
            <pc:docMk/>
            <pc:sldMk cId="3351872524" sldId="264"/>
            <ac:spMk id="16" creationId="{754C276F-2CF0-C8D3-81AA-96C8545CA0C6}"/>
          </ac:spMkLst>
        </pc:spChg>
        <pc:spChg chg="add del mod">
          <ac:chgData name="Yan Zhao" userId="3b5aa489-47ea-468b-84f4-bfcef63c3ea6" providerId="ADAL" clId="{CF54C041-53B9-5E4A-AEFB-81688426B434}" dt="2024-05-16T12:54:59.683" v="378" actId="478"/>
          <ac:spMkLst>
            <pc:docMk/>
            <pc:sldMk cId="3351872524" sldId="264"/>
            <ac:spMk id="17" creationId="{B681DAD9-E3ED-8967-42D1-0120F846C6F7}"/>
          </ac:spMkLst>
        </pc:spChg>
        <pc:spChg chg="add mod">
          <ac:chgData name="Yan Zhao" userId="3b5aa489-47ea-468b-84f4-bfcef63c3ea6" providerId="ADAL" clId="{CF54C041-53B9-5E4A-AEFB-81688426B434}" dt="2024-05-16T12:59:19.886" v="420" actId="1076"/>
          <ac:spMkLst>
            <pc:docMk/>
            <pc:sldMk cId="3351872524" sldId="264"/>
            <ac:spMk id="18" creationId="{FDDC629D-81D5-A2CE-084B-668A27E96833}"/>
          </ac:spMkLst>
        </pc:spChg>
        <pc:spChg chg="add mod">
          <ac:chgData name="Yan Zhao" userId="3b5aa489-47ea-468b-84f4-bfcef63c3ea6" providerId="ADAL" clId="{CF54C041-53B9-5E4A-AEFB-81688426B434}" dt="2024-05-16T12:59:19.886" v="420" actId="1076"/>
          <ac:spMkLst>
            <pc:docMk/>
            <pc:sldMk cId="3351872524" sldId="264"/>
            <ac:spMk id="19" creationId="{CE4B57A4-D9F6-2AFF-B0B7-89E3DC7ADCA3}"/>
          </ac:spMkLst>
        </pc:spChg>
        <pc:spChg chg="add mod">
          <ac:chgData name="Yan Zhao" userId="3b5aa489-47ea-468b-84f4-bfcef63c3ea6" providerId="ADAL" clId="{CF54C041-53B9-5E4A-AEFB-81688426B434}" dt="2024-05-19T09:57:18.522" v="506" actId="20577"/>
          <ac:spMkLst>
            <pc:docMk/>
            <pc:sldMk cId="3351872524" sldId="264"/>
            <ac:spMk id="22" creationId="{D4BDFCED-F0C8-8336-2BF5-29451639B80C}"/>
          </ac:spMkLst>
        </pc:spChg>
        <pc:spChg chg="add mod">
          <ac:chgData name="Yan Zhao" userId="3b5aa489-47ea-468b-84f4-bfcef63c3ea6" providerId="ADAL" clId="{CF54C041-53B9-5E4A-AEFB-81688426B434}" dt="2024-05-16T12:59:40.066" v="423" actId="1076"/>
          <ac:spMkLst>
            <pc:docMk/>
            <pc:sldMk cId="3351872524" sldId="264"/>
            <ac:spMk id="23" creationId="{3FD1B32C-704B-B26B-B3C8-D814EE63C522}"/>
          </ac:spMkLst>
        </pc:spChg>
        <pc:spChg chg="add mod">
          <ac:chgData name="Yan Zhao" userId="3b5aa489-47ea-468b-84f4-bfcef63c3ea6" providerId="ADAL" clId="{CF54C041-53B9-5E4A-AEFB-81688426B434}" dt="2024-05-16T12:59:32.790" v="422" actId="1076"/>
          <ac:spMkLst>
            <pc:docMk/>
            <pc:sldMk cId="3351872524" sldId="264"/>
            <ac:spMk id="24" creationId="{53B689EF-4C76-960A-8B77-2C63BA926299}"/>
          </ac:spMkLst>
        </pc:spChg>
        <pc:picChg chg="add mod">
          <ac:chgData name="Yan Zhao" userId="3b5aa489-47ea-468b-84f4-bfcef63c3ea6" providerId="ADAL" clId="{CF54C041-53B9-5E4A-AEFB-81688426B434}" dt="2024-05-16T12:59:09.177" v="419" actId="12788"/>
          <ac:picMkLst>
            <pc:docMk/>
            <pc:sldMk cId="3351872524" sldId="264"/>
            <ac:picMk id="2" creationId="{DEA39A4E-7462-58F9-87E6-C3A4D0CD5DBF}"/>
          </ac:picMkLst>
        </pc:picChg>
        <pc:picChg chg="add mod">
          <ac:chgData name="Yan Zhao" userId="3b5aa489-47ea-468b-84f4-bfcef63c3ea6" providerId="ADAL" clId="{CF54C041-53B9-5E4A-AEFB-81688426B434}" dt="2024-05-16T12:59:09.177" v="419" actId="12788"/>
          <ac:picMkLst>
            <pc:docMk/>
            <pc:sldMk cId="3351872524" sldId="264"/>
            <ac:picMk id="5" creationId="{F0D76EC9-5DA3-B944-E782-91846DDF293F}"/>
          </ac:picMkLst>
        </pc:picChg>
        <pc:picChg chg="add mod">
          <ac:chgData name="Yan Zhao" userId="3b5aa489-47ea-468b-84f4-bfcef63c3ea6" providerId="ADAL" clId="{CF54C041-53B9-5E4A-AEFB-81688426B434}" dt="2024-05-16T12:59:19.886" v="420" actId="1076"/>
          <ac:picMkLst>
            <pc:docMk/>
            <pc:sldMk cId="3351872524" sldId="264"/>
            <ac:picMk id="7" creationId="{B7362714-A31D-7B84-E53A-24E260474E9C}"/>
          </ac:picMkLst>
        </pc:picChg>
        <pc:picChg chg="add mod">
          <ac:chgData name="Yan Zhao" userId="3b5aa489-47ea-468b-84f4-bfcef63c3ea6" providerId="ADAL" clId="{CF54C041-53B9-5E4A-AEFB-81688426B434}" dt="2024-05-16T12:59:09.177" v="419" actId="12788"/>
          <ac:picMkLst>
            <pc:docMk/>
            <pc:sldMk cId="3351872524" sldId="264"/>
            <ac:picMk id="10" creationId="{470108E5-04D6-992D-B3B0-31BE21952016}"/>
          </ac:picMkLst>
        </pc:picChg>
        <pc:picChg chg="add mod">
          <ac:chgData name="Yan Zhao" userId="3b5aa489-47ea-468b-84f4-bfcef63c3ea6" providerId="ADAL" clId="{CF54C041-53B9-5E4A-AEFB-81688426B434}" dt="2024-05-16T12:59:19.886" v="420" actId="1076"/>
          <ac:picMkLst>
            <pc:docMk/>
            <pc:sldMk cId="3351872524" sldId="264"/>
            <ac:picMk id="12" creationId="{60F92F98-5DB7-FDD6-03AA-EC5A84BA92B2}"/>
          </ac:picMkLst>
        </pc:picChg>
        <pc:picChg chg="add mod">
          <ac:chgData name="Yan Zhao" userId="3b5aa489-47ea-468b-84f4-bfcef63c3ea6" providerId="ADAL" clId="{CF54C041-53B9-5E4A-AEFB-81688426B434}" dt="2024-05-16T12:59:19.886" v="420" actId="1076"/>
          <ac:picMkLst>
            <pc:docMk/>
            <pc:sldMk cId="3351872524" sldId="264"/>
            <ac:picMk id="14" creationId="{3298D460-BB82-3086-660B-C3D049DBC393}"/>
          </ac:picMkLst>
        </pc:picChg>
        <pc:picChg chg="add mod">
          <ac:chgData name="Yan Zhao" userId="3b5aa489-47ea-468b-84f4-bfcef63c3ea6" providerId="ADAL" clId="{CF54C041-53B9-5E4A-AEFB-81688426B434}" dt="2024-05-16T12:58:34.394" v="415" actId="1076"/>
          <ac:picMkLst>
            <pc:docMk/>
            <pc:sldMk cId="3351872524" sldId="264"/>
            <ac:picMk id="20" creationId="{1F555ED3-FB48-D942-B7A8-D8D6F44E56C9}"/>
          </ac:picMkLst>
        </pc:picChg>
        <pc:picChg chg="add mod">
          <ac:chgData name="Yan Zhao" userId="3b5aa489-47ea-468b-84f4-bfcef63c3ea6" providerId="ADAL" clId="{CF54C041-53B9-5E4A-AEFB-81688426B434}" dt="2024-05-16T12:58:34.394" v="415" actId="1076"/>
          <ac:picMkLst>
            <pc:docMk/>
            <pc:sldMk cId="3351872524" sldId="264"/>
            <ac:picMk id="21" creationId="{0D7D2C61-3280-9D88-0B27-3F4C7AC62655}"/>
          </ac:picMkLst>
        </pc:picChg>
      </pc:sldChg>
      <pc:sldChg chg="addSp delSp modSp new mod">
        <pc:chgData name="Yan Zhao" userId="3b5aa489-47ea-468b-84f4-bfcef63c3ea6" providerId="ADAL" clId="{CF54C041-53B9-5E4A-AEFB-81688426B434}" dt="2024-05-19T09:55:58.609" v="502" actId="20577"/>
        <pc:sldMkLst>
          <pc:docMk/>
          <pc:sldMk cId="683148836" sldId="265"/>
        </pc:sldMkLst>
        <pc:spChg chg="add del mod">
          <ac:chgData name="Yan Zhao" userId="3b5aa489-47ea-468b-84f4-bfcef63c3ea6" providerId="ADAL" clId="{CF54C041-53B9-5E4A-AEFB-81688426B434}" dt="2024-05-16T12:51:22.151" v="335" actId="478"/>
          <ac:spMkLst>
            <pc:docMk/>
            <pc:sldMk cId="683148836" sldId="265"/>
            <ac:spMk id="6" creationId="{4A2EAC85-8A7E-8B73-1B56-38147FB07E40}"/>
          </ac:spMkLst>
        </pc:spChg>
        <pc:spChg chg="add mod">
          <ac:chgData name="Yan Zhao" userId="3b5aa489-47ea-468b-84f4-bfcef63c3ea6" providerId="ADAL" clId="{CF54C041-53B9-5E4A-AEFB-81688426B434}" dt="2024-05-19T09:55:58.609" v="502" actId="20577"/>
          <ac:spMkLst>
            <pc:docMk/>
            <pc:sldMk cId="683148836" sldId="265"/>
            <ac:spMk id="7" creationId="{B6DD8470-7784-6FAD-45F9-FF84BBA4C24A}"/>
          </ac:spMkLst>
        </pc:spChg>
        <pc:spChg chg="add del mod">
          <ac:chgData name="Yan Zhao" userId="3b5aa489-47ea-468b-84f4-bfcef63c3ea6" providerId="ADAL" clId="{CF54C041-53B9-5E4A-AEFB-81688426B434}" dt="2024-05-17T13:02:54.372" v="481" actId="478"/>
          <ac:spMkLst>
            <pc:docMk/>
            <pc:sldMk cId="683148836" sldId="265"/>
            <ac:spMk id="8" creationId="{976E7C0E-FEB8-35B1-7B9A-D248D0F1D09F}"/>
          </ac:spMkLst>
        </pc:spChg>
        <pc:spChg chg="add del mod">
          <ac:chgData name="Yan Zhao" userId="3b5aa489-47ea-468b-84f4-bfcef63c3ea6" providerId="ADAL" clId="{CF54C041-53B9-5E4A-AEFB-81688426B434}" dt="2024-05-17T13:02:57.057" v="482" actId="478"/>
          <ac:spMkLst>
            <pc:docMk/>
            <pc:sldMk cId="683148836" sldId="265"/>
            <ac:spMk id="9" creationId="{89C4BB2B-030F-9FD2-E731-67F3F123207D}"/>
          </ac:spMkLst>
        </pc:spChg>
        <pc:spChg chg="add del mod">
          <ac:chgData name="Yan Zhao" userId="3b5aa489-47ea-468b-84f4-bfcef63c3ea6" providerId="ADAL" clId="{CF54C041-53B9-5E4A-AEFB-81688426B434}" dt="2024-05-17T13:02:54.372" v="481" actId="478"/>
          <ac:spMkLst>
            <pc:docMk/>
            <pc:sldMk cId="683148836" sldId="265"/>
            <ac:spMk id="10" creationId="{B5D65A09-C0CF-4237-A1E2-808AA8A27EED}"/>
          </ac:spMkLst>
        </pc:spChg>
        <pc:spChg chg="add del mod">
          <ac:chgData name="Yan Zhao" userId="3b5aa489-47ea-468b-84f4-bfcef63c3ea6" providerId="ADAL" clId="{CF54C041-53B9-5E4A-AEFB-81688426B434}" dt="2024-05-16T12:52:22.756" v="342" actId="478"/>
          <ac:spMkLst>
            <pc:docMk/>
            <pc:sldMk cId="683148836" sldId="265"/>
            <ac:spMk id="11" creationId="{38AB3DDC-DA81-E091-6E45-2172A465C135}"/>
          </ac:spMkLst>
        </pc:spChg>
        <pc:picChg chg="add del mod">
          <ac:chgData name="Yan Zhao" userId="3b5aa489-47ea-468b-84f4-bfcef63c3ea6" providerId="ADAL" clId="{CF54C041-53B9-5E4A-AEFB-81688426B434}" dt="2024-05-17T13:02:52.071" v="480" actId="478"/>
          <ac:picMkLst>
            <pc:docMk/>
            <pc:sldMk cId="683148836" sldId="265"/>
            <ac:picMk id="2" creationId="{F0CEA876-7783-E59A-D121-8E3F52392CF0}"/>
          </ac:picMkLst>
        </pc:picChg>
        <pc:picChg chg="add del mod">
          <ac:chgData name="Yan Zhao" userId="3b5aa489-47ea-468b-84f4-bfcef63c3ea6" providerId="ADAL" clId="{CF54C041-53B9-5E4A-AEFB-81688426B434}" dt="2024-05-17T13:02:52.071" v="480" actId="478"/>
          <ac:picMkLst>
            <pc:docMk/>
            <pc:sldMk cId="683148836" sldId="265"/>
            <ac:picMk id="3" creationId="{EC4A72E4-0C38-BEFD-5CA5-DC4A6ABAFE51}"/>
          </ac:picMkLst>
        </pc:picChg>
        <pc:picChg chg="add mod">
          <ac:chgData name="Yan Zhao" userId="3b5aa489-47ea-468b-84f4-bfcef63c3ea6" providerId="ADAL" clId="{CF54C041-53B9-5E4A-AEFB-81688426B434}" dt="2024-05-17T13:03:00.194" v="483" actId="1076"/>
          <ac:picMkLst>
            <pc:docMk/>
            <pc:sldMk cId="683148836" sldId="265"/>
            <ac:picMk id="4" creationId="{2DAD92F4-C52B-7FD6-3CE5-71581230C4BC}"/>
          </ac:picMkLst>
        </pc:picChg>
      </pc:sldChg>
      <pc:sldChg chg="new del">
        <pc:chgData name="Yan Zhao" userId="3b5aa489-47ea-468b-84f4-bfcef63c3ea6" providerId="ADAL" clId="{CF54C041-53B9-5E4A-AEFB-81688426B434}" dt="2024-05-16T12:19:02.020" v="288" actId="680"/>
        <pc:sldMkLst>
          <pc:docMk/>
          <pc:sldMk cId="807886928" sldId="266"/>
        </pc:sldMkLst>
      </pc:sldChg>
      <pc:sldChg chg="addSp modSp new del mod">
        <pc:chgData name="Yan Zhao" userId="3b5aa489-47ea-468b-84f4-bfcef63c3ea6" providerId="ADAL" clId="{CF54C041-53B9-5E4A-AEFB-81688426B434}" dt="2024-05-16T12:49:02.231" v="316" actId="2696"/>
        <pc:sldMkLst>
          <pc:docMk/>
          <pc:sldMk cId="1955327337" sldId="266"/>
        </pc:sldMkLst>
        <pc:spChg chg="add mod">
          <ac:chgData name="Yan Zhao" userId="3b5aa489-47ea-468b-84f4-bfcef63c3ea6" providerId="ADAL" clId="{CF54C041-53B9-5E4A-AEFB-81688426B434}" dt="2024-05-16T12:19:21.694" v="292" actId="1076"/>
          <ac:spMkLst>
            <pc:docMk/>
            <pc:sldMk cId="1955327337" sldId="266"/>
            <ac:spMk id="3" creationId="{18ACCE61-4A88-43DE-9A9F-6748355A2A79}"/>
          </ac:spMkLst>
        </pc:spChg>
      </pc:sldChg>
      <pc:sldChg chg="addSp delSp modSp new mod">
        <pc:chgData name="Yan Zhao" userId="3b5aa489-47ea-468b-84f4-bfcef63c3ea6" providerId="ADAL" clId="{CF54C041-53B9-5E4A-AEFB-81688426B434}" dt="2024-05-19T09:57:15.320" v="504" actId="20577"/>
        <pc:sldMkLst>
          <pc:docMk/>
          <pc:sldMk cId="2976955891" sldId="267"/>
        </pc:sldMkLst>
        <pc:spChg chg="add del mod">
          <ac:chgData name="Yan Zhao" userId="3b5aa489-47ea-468b-84f4-bfcef63c3ea6" providerId="ADAL" clId="{CF54C041-53B9-5E4A-AEFB-81688426B434}" dt="2024-05-16T12:49:00.185" v="315" actId="478"/>
          <ac:spMkLst>
            <pc:docMk/>
            <pc:sldMk cId="2976955891" sldId="267"/>
            <ac:spMk id="4" creationId="{24C9A0D3-864C-DBF2-A3D8-EDC10B9D823F}"/>
          </ac:spMkLst>
        </pc:spChg>
        <pc:spChg chg="add mod">
          <ac:chgData name="Yan Zhao" userId="3b5aa489-47ea-468b-84f4-bfcef63c3ea6" providerId="ADAL" clId="{CF54C041-53B9-5E4A-AEFB-81688426B434}" dt="2024-05-19T09:57:15.320" v="504" actId="20577"/>
          <ac:spMkLst>
            <pc:docMk/>
            <pc:sldMk cId="2976955891" sldId="267"/>
            <ac:spMk id="5" creationId="{7D856276-2EC8-61D4-3494-15D24A1B6DFD}"/>
          </ac:spMkLst>
        </pc:spChg>
        <pc:picChg chg="add del mod">
          <ac:chgData name="Yan Zhao" userId="3b5aa489-47ea-468b-84f4-bfcef63c3ea6" providerId="ADAL" clId="{CF54C041-53B9-5E4A-AEFB-81688426B434}" dt="2024-05-16T19:39:04.790" v="457" actId="478"/>
          <ac:picMkLst>
            <pc:docMk/>
            <pc:sldMk cId="2976955891" sldId="267"/>
            <ac:picMk id="2" creationId="{696A2C52-A27D-EBCC-1314-09B7DCA12C94}"/>
          </ac:picMkLst>
        </pc:picChg>
        <pc:picChg chg="add mod">
          <ac:chgData name="Yan Zhao" userId="3b5aa489-47ea-468b-84f4-bfcef63c3ea6" providerId="ADAL" clId="{CF54C041-53B9-5E4A-AEFB-81688426B434}" dt="2024-05-16T19:40:32.529" v="479" actId="1076"/>
          <ac:picMkLst>
            <pc:docMk/>
            <pc:sldMk cId="2976955891" sldId="267"/>
            <ac:picMk id="3" creationId="{AA50BA16-1E3C-2BDF-028C-8EB619A3A24C}"/>
          </ac:picMkLst>
        </pc:picChg>
        <pc:picChg chg="add mod">
          <ac:chgData name="Yan Zhao" userId="3b5aa489-47ea-468b-84f4-bfcef63c3ea6" providerId="ADAL" clId="{CF54C041-53B9-5E4A-AEFB-81688426B434}" dt="2024-05-16T19:40:26.884" v="477" actId="1076"/>
          <ac:picMkLst>
            <pc:docMk/>
            <pc:sldMk cId="2976955891" sldId="267"/>
            <ac:picMk id="4" creationId="{FFED1D9F-14C2-257E-5D72-E587C67372EF}"/>
          </ac:picMkLst>
        </pc:picChg>
        <pc:picChg chg="add mod">
          <ac:chgData name="Yan Zhao" userId="3b5aa489-47ea-468b-84f4-bfcef63c3ea6" providerId="ADAL" clId="{CF54C041-53B9-5E4A-AEFB-81688426B434}" dt="2024-05-16T19:40:30.563" v="478" actId="1076"/>
          <ac:picMkLst>
            <pc:docMk/>
            <pc:sldMk cId="2976955891" sldId="267"/>
            <ac:picMk id="6" creationId="{4A252A85-1C52-5C51-B812-5B10B8A84D01}"/>
          </ac:picMkLst>
        </pc:picChg>
        <pc:picChg chg="add mod">
          <ac:chgData name="Yan Zhao" userId="3b5aa489-47ea-468b-84f4-bfcef63c3ea6" providerId="ADAL" clId="{CF54C041-53B9-5E4A-AEFB-81688426B434}" dt="2024-05-16T19:40:25.173" v="476" actId="1076"/>
          <ac:picMkLst>
            <pc:docMk/>
            <pc:sldMk cId="2976955891" sldId="267"/>
            <ac:picMk id="7" creationId="{A7131832-B479-C19B-CB0D-FE2E6272CDCF}"/>
          </ac:picMkLst>
        </pc:picChg>
        <pc:picChg chg="add mod">
          <ac:chgData name="Yan Zhao" userId="3b5aa489-47ea-468b-84f4-bfcef63c3ea6" providerId="ADAL" clId="{CF54C041-53B9-5E4A-AEFB-81688426B434}" dt="2024-05-16T19:40:20.626" v="473" actId="1076"/>
          <ac:picMkLst>
            <pc:docMk/>
            <pc:sldMk cId="2976955891" sldId="267"/>
            <ac:picMk id="8" creationId="{B314C09E-1484-5B70-95AF-CDFC4223C272}"/>
          </ac:picMkLst>
        </pc:picChg>
      </pc:sldChg>
      <pc:sldChg chg="addSp delSp modSp new mod">
        <pc:chgData name="Yan Zhao" userId="3b5aa489-47ea-468b-84f4-bfcef63c3ea6" providerId="ADAL" clId="{CF54C041-53B9-5E4A-AEFB-81688426B434}" dt="2024-05-19T10:24:03.937" v="509" actId="1076"/>
        <pc:sldMkLst>
          <pc:docMk/>
          <pc:sldMk cId="3987769180" sldId="268"/>
        </pc:sldMkLst>
        <pc:spChg chg="add mod">
          <ac:chgData name="Yan Zhao" userId="3b5aa489-47ea-468b-84f4-bfcef63c3ea6" providerId="ADAL" clId="{CF54C041-53B9-5E4A-AEFB-81688426B434}" dt="2024-05-19T09:49:01.333" v="500" actId="20577"/>
          <ac:spMkLst>
            <pc:docMk/>
            <pc:sldMk cId="3987769180" sldId="268"/>
            <ac:spMk id="4" creationId="{7C319519-E693-82BA-EBC0-D5DE08AD529F}"/>
          </ac:spMkLst>
        </pc:spChg>
        <pc:picChg chg="add del mod">
          <ac:chgData name="Yan Zhao" userId="3b5aa489-47ea-468b-84f4-bfcef63c3ea6" providerId="ADAL" clId="{CF54C041-53B9-5E4A-AEFB-81688426B434}" dt="2024-05-18T23:51:30.406" v="488" actId="478"/>
          <ac:picMkLst>
            <pc:docMk/>
            <pc:sldMk cId="3987769180" sldId="268"/>
            <ac:picMk id="2" creationId="{6D903210-2A8A-5B2C-C9AE-E725B807B516}"/>
          </ac:picMkLst>
        </pc:picChg>
        <pc:picChg chg="add mod">
          <ac:chgData name="Yan Zhao" userId="3b5aa489-47ea-468b-84f4-bfcef63c3ea6" providerId="ADAL" clId="{CF54C041-53B9-5E4A-AEFB-81688426B434}" dt="2024-05-19T10:24:03.937" v="509" actId="1076"/>
          <ac:picMkLst>
            <pc:docMk/>
            <pc:sldMk cId="3987769180" sldId="268"/>
            <ac:picMk id="3" creationId="{E6804CED-225C-A19C-20EA-F13F16490912}"/>
          </ac:picMkLst>
        </pc:picChg>
      </pc:sldChg>
      <pc:sldChg chg="new del">
        <pc:chgData name="Yan Zhao" userId="3b5aa489-47ea-468b-84f4-bfcef63c3ea6" providerId="ADAL" clId="{CF54C041-53B9-5E4A-AEFB-81688426B434}" dt="2024-05-23T08:47:22.052" v="511" actId="2696"/>
        <pc:sldMkLst>
          <pc:docMk/>
          <pc:sldMk cId="3839327059" sldId="269"/>
        </pc:sldMkLst>
      </pc:sldChg>
    </pc:docChg>
  </pc:docChgLst>
  <pc:docChgLst>
    <pc:chgData name="Yan Zhao" userId="3b5aa489-47ea-468b-84f4-bfcef63c3ea6" providerId="ADAL" clId="{6E3AEEA6-7BC3-234E-985F-338BB0878DA6}"/>
    <pc:docChg chg="undo custSel modSld">
      <pc:chgData name="Yan Zhao" userId="3b5aa489-47ea-468b-84f4-bfcef63c3ea6" providerId="ADAL" clId="{6E3AEEA6-7BC3-234E-985F-338BB0878DA6}" dt="2024-07-30T14:13:27.194" v="104" actId="113"/>
      <pc:docMkLst>
        <pc:docMk/>
      </pc:docMkLst>
      <pc:sldChg chg="addSp delSp modSp mod">
        <pc:chgData name="Yan Zhao" userId="3b5aa489-47ea-468b-84f4-bfcef63c3ea6" providerId="ADAL" clId="{6E3AEEA6-7BC3-234E-985F-338BB0878DA6}" dt="2024-07-30T13:44:51.634" v="95" actId="2711"/>
        <pc:sldMkLst>
          <pc:docMk/>
          <pc:sldMk cId="1116375164" sldId="257"/>
        </pc:sldMkLst>
        <pc:spChg chg="add mod">
          <ac:chgData name="Yan Zhao" userId="3b5aa489-47ea-468b-84f4-bfcef63c3ea6" providerId="ADAL" clId="{6E3AEEA6-7BC3-234E-985F-338BB0878DA6}" dt="2024-07-30T13:44:51.634" v="95" actId="2711"/>
          <ac:spMkLst>
            <pc:docMk/>
            <pc:sldMk cId="1116375164" sldId="257"/>
            <ac:spMk id="3" creationId="{61E8C629-A79E-75C1-B936-0B3153ECFEFD}"/>
          </ac:spMkLst>
        </pc:spChg>
        <pc:spChg chg="del mod">
          <ac:chgData name="Yan Zhao" userId="3b5aa489-47ea-468b-84f4-bfcef63c3ea6" providerId="ADAL" clId="{6E3AEEA6-7BC3-234E-985F-338BB0878DA6}" dt="2024-07-30T11:11:53.630" v="10"/>
          <ac:spMkLst>
            <pc:docMk/>
            <pc:sldMk cId="1116375164" sldId="257"/>
            <ac:spMk id="5" creationId="{E1C42691-B67D-7CC6-6377-A485AF292C47}"/>
          </ac:spMkLst>
        </pc:spChg>
      </pc:sldChg>
      <pc:sldChg chg="addSp delSp modSp mod">
        <pc:chgData name="Yan Zhao" userId="3b5aa489-47ea-468b-84f4-bfcef63c3ea6" providerId="ADAL" clId="{6E3AEEA6-7BC3-234E-985F-338BB0878DA6}" dt="2024-07-30T13:44:42.686" v="93" actId="20577"/>
        <pc:sldMkLst>
          <pc:docMk/>
          <pc:sldMk cId="2903892845" sldId="259"/>
        </pc:sldMkLst>
        <pc:spChg chg="del">
          <ac:chgData name="Yan Zhao" userId="3b5aa489-47ea-468b-84f4-bfcef63c3ea6" providerId="ADAL" clId="{6E3AEEA6-7BC3-234E-985F-338BB0878DA6}" dt="2024-07-30T12:18:35.166" v="84" actId="478"/>
          <ac:spMkLst>
            <pc:docMk/>
            <pc:sldMk cId="2903892845" sldId="259"/>
            <ac:spMk id="3" creationId="{FFEF2F04-1357-A1AC-0112-067055DA1BAA}"/>
          </ac:spMkLst>
        </pc:spChg>
        <pc:spChg chg="add mod">
          <ac:chgData name="Yan Zhao" userId="3b5aa489-47ea-468b-84f4-bfcef63c3ea6" providerId="ADAL" clId="{6E3AEEA6-7BC3-234E-985F-338BB0878DA6}" dt="2024-07-30T13:44:42.686" v="93" actId="20577"/>
          <ac:spMkLst>
            <pc:docMk/>
            <pc:sldMk cId="2903892845" sldId="259"/>
            <ac:spMk id="4" creationId="{3C1A9C47-5920-04F9-0D73-106ED505A8A1}"/>
          </ac:spMkLst>
        </pc:spChg>
      </pc:sldChg>
      <pc:sldChg chg="addSp delSp modSp mod">
        <pc:chgData name="Yan Zhao" userId="3b5aa489-47ea-468b-84f4-bfcef63c3ea6" providerId="ADAL" clId="{6E3AEEA6-7BC3-234E-985F-338BB0878DA6}" dt="2024-07-30T13:45:33.921" v="103" actId="255"/>
        <pc:sldMkLst>
          <pc:docMk/>
          <pc:sldMk cId="3351872524" sldId="264"/>
        </pc:sldMkLst>
        <pc:spChg chg="add mod">
          <ac:chgData name="Yan Zhao" userId="3b5aa489-47ea-468b-84f4-bfcef63c3ea6" providerId="ADAL" clId="{6E3AEEA6-7BC3-234E-985F-338BB0878DA6}" dt="2024-07-30T13:45:33.921" v="103" actId="255"/>
          <ac:spMkLst>
            <pc:docMk/>
            <pc:sldMk cId="3351872524" sldId="264"/>
            <ac:spMk id="3" creationId="{7258F476-5618-8624-9F10-2CB238FEFAD7}"/>
          </ac:spMkLst>
        </pc:spChg>
        <pc:spChg chg="mod">
          <ac:chgData name="Yan Zhao" userId="3b5aa489-47ea-468b-84f4-bfcef63c3ea6" providerId="ADAL" clId="{6E3AEEA6-7BC3-234E-985F-338BB0878DA6}" dt="2024-07-30T12:18:24.400" v="82" actId="1076"/>
          <ac:spMkLst>
            <pc:docMk/>
            <pc:sldMk cId="3351872524" sldId="264"/>
            <ac:spMk id="4" creationId="{61906F06-18EB-5640-782C-D1BDC24CF039}"/>
          </ac:spMkLst>
        </pc:spChg>
        <pc:spChg chg="mod">
          <ac:chgData name="Yan Zhao" userId="3b5aa489-47ea-468b-84f4-bfcef63c3ea6" providerId="ADAL" clId="{6E3AEEA6-7BC3-234E-985F-338BB0878DA6}" dt="2024-07-30T12:18:24.400" v="82" actId="1076"/>
          <ac:spMkLst>
            <pc:docMk/>
            <pc:sldMk cId="3351872524" sldId="264"/>
            <ac:spMk id="9" creationId="{92DFF016-C66A-DB72-DD2D-F45755C209CB}"/>
          </ac:spMkLst>
        </pc:spChg>
        <pc:spChg chg="del mod">
          <ac:chgData name="Yan Zhao" userId="3b5aa489-47ea-468b-84f4-bfcef63c3ea6" providerId="ADAL" clId="{6E3AEEA6-7BC3-234E-985F-338BB0878DA6}" dt="2024-07-30T12:18:01.061" v="81" actId="478"/>
          <ac:spMkLst>
            <pc:docMk/>
            <pc:sldMk cId="3351872524" sldId="264"/>
            <ac:spMk id="22" creationId="{D4BDFCED-F0C8-8336-2BF5-29451639B80C}"/>
          </ac:spMkLst>
        </pc:spChg>
        <pc:spChg chg="mod">
          <ac:chgData name="Yan Zhao" userId="3b5aa489-47ea-468b-84f4-bfcef63c3ea6" providerId="ADAL" clId="{6E3AEEA6-7BC3-234E-985F-338BB0878DA6}" dt="2024-07-30T12:18:24.400" v="82" actId="1076"/>
          <ac:spMkLst>
            <pc:docMk/>
            <pc:sldMk cId="3351872524" sldId="264"/>
            <ac:spMk id="29" creationId="{75B6C0AE-ECA9-3332-A6E2-BAF10EDB530A}"/>
          </ac:spMkLst>
        </pc:spChg>
        <pc:picChg chg="mod">
          <ac:chgData name="Yan Zhao" userId="3b5aa489-47ea-468b-84f4-bfcef63c3ea6" providerId="ADAL" clId="{6E3AEEA6-7BC3-234E-985F-338BB0878DA6}" dt="2024-07-30T12:18:24.400" v="82" actId="1076"/>
          <ac:picMkLst>
            <pc:docMk/>
            <pc:sldMk cId="3351872524" sldId="264"/>
            <ac:picMk id="8" creationId="{9F3DAC96-4CD1-956C-C4EA-FC753933D894}"/>
          </ac:picMkLst>
        </pc:picChg>
        <pc:picChg chg="mod">
          <ac:chgData name="Yan Zhao" userId="3b5aa489-47ea-468b-84f4-bfcef63c3ea6" providerId="ADAL" clId="{6E3AEEA6-7BC3-234E-985F-338BB0878DA6}" dt="2024-07-30T12:18:24.400" v="82" actId="1076"/>
          <ac:picMkLst>
            <pc:docMk/>
            <pc:sldMk cId="3351872524" sldId="264"/>
            <ac:picMk id="17" creationId="{66B4217C-108E-4881-0AA8-23A6A4032BAE}"/>
          </ac:picMkLst>
        </pc:picChg>
        <pc:picChg chg="mod">
          <ac:chgData name="Yan Zhao" userId="3b5aa489-47ea-468b-84f4-bfcef63c3ea6" providerId="ADAL" clId="{6E3AEEA6-7BC3-234E-985F-338BB0878DA6}" dt="2024-07-30T12:18:24.400" v="82" actId="1076"/>
          <ac:picMkLst>
            <pc:docMk/>
            <pc:sldMk cId="3351872524" sldId="264"/>
            <ac:picMk id="31" creationId="{77F19C0B-80BF-DA5E-B80A-916128A7DF98}"/>
          </ac:picMkLst>
        </pc:picChg>
      </pc:sldChg>
      <pc:sldChg chg="addSp delSp modSp mod">
        <pc:chgData name="Yan Zhao" userId="3b5aa489-47ea-468b-84f4-bfcef63c3ea6" providerId="ADAL" clId="{6E3AEEA6-7BC3-234E-985F-338BB0878DA6}" dt="2024-07-30T13:45:16.603" v="99" actId="255"/>
        <pc:sldMkLst>
          <pc:docMk/>
          <pc:sldMk cId="683148836" sldId="265"/>
        </pc:sldMkLst>
        <pc:spChg chg="add mod">
          <ac:chgData name="Yan Zhao" userId="3b5aa489-47ea-468b-84f4-bfcef63c3ea6" providerId="ADAL" clId="{6E3AEEA6-7BC3-234E-985F-338BB0878DA6}" dt="2024-07-30T13:45:16.603" v="99" actId="255"/>
          <ac:spMkLst>
            <pc:docMk/>
            <pc:sldMk cId="683148836" sldId="265"/>
            <ac:spMk id="3" creationId="{369C9AB1-2DA8-36C9-7530-FEE48B75485A}"/>
          </ac:spMkLst>
        </pc:spChg>
        <pc:spChg chg="del">
          <ac:chgData name="Yan Zhao" userId="3b5aa489-47ea-468b-84f4-bfcef63c3ea6" providerId="ADAL" clId="{6E3AEEA6-7BC3-234E-985F-338BB0878DA6}" dt="2024-07-30T12:18:31.544" v="83" actId="478"/>
          <ac:spMkLst>
            <pc:docMk/>
            <pc:sldMk cId="683148836" sldId="265"/>
            <ac:spMk id="7" creationId="{B6DD8470-7784-6FAD-45F9-FF84BBA4C24A}"/>
          </ac:spMkLst>
        </pc:spChg>
      </pc:sldChg>
      <pc:sldChg chg="addSp delSp modSp mod">
        <pc:chgData name="Yan Zhao" userId="3b5aa489-47ea-468b-84f4-bfcef63c3ea6" providerId="ADAL" clId="{6E3AEEA6-7BC3-234E-985F-338BB0878DA6}" dt="2024-07-30T13:45:25.253" v="101" actId="255"/>
        <pc:sldMkLst>
          <pc:docMk/>
          <pc:sldMk cId="2976955891" sldId="267"/>
        </pc:sldMkLst>
        <pc:spChg chg="del mod">
          <ac:chgData name="Yan Zhao" userId="3b5aa489-47ea-468b-84f4-bfcef63c3ea6" providerId="ADAL" clId="{6E3AEEA6-7BC3-234E-985F-338BB0878DA6}" dt="2024-07-30T12:18:40.503" v="86" actId="478"/>
          <ac:spMkLst>
            <pc:docMk/>
            <pc:sldMk cId="2976955891" sldId="267"/>
            <ac:spMk id="2" creationId="{0DB3AD95-C027-02B9-D35A-015A76E7EB74}"/>
          </ac:spMkLst>
        </pc:spChg>
        <pc:spChg chg="add mod">
          <ac:chgData name="Yan Zhao" userId="3b5aa489-47ea-468b-84f4-bfcef63c3ea6" providerId="ADAL" clId="{6E3AEEA6-7BC3-234E-985F-338BB0878DA6}" dt="2024-07-30T13:45:25.253" v="101" actId="255"/>
          <ac:spMkLst>
            <pc:docMk/>
            <pc:sldMk cId="2976955891" sldId="267"/>
            <ac:spMk id="5" creationId="{CF3087B2-DBF6-BB4F-F25C-0B62FC127DE1}"/>
          </ac:spMkLst>
        </pc:spChg>
      </pc:sldChg>
      <pc:sldChg chg="addSp delSp modSp mod">
        <pc:chgData name="Yan Zhao" userId="3b5aa489-47ea-468b-84f4-bfcef63c3ea6" providerId="ADAL" clId="{6E3AEEA6-7BC3-234E-985F-338BB0878DA6}" dt="2024-07-30T14:13:27.194" v="104" actId="113"/>
        <pc:sldMkLst>
          <pc:docMk/>
          <pc:sldMk cId="3987769180" sldId="268"/>
        </pc:sldMkLst>
        <pc:spChg chg="add mod">
          <ac:chgData name="Yan Zhao" userId="3b5aa489-47ea-468b-84f4-bfcef63c3ea6" providerId="ADAL" clId="{6E3AEEA6-7BC3-234E-985F-338BB0878DA6}" dt="2024-07-30T14:13:27.194" v="104" actId="113"/>
          <ac:spMkLst>
            <pc:docMk/>
            <pc:sldMk cId="3987769180" sldId="268"/>
            <ac:spMk id="2" creationId="{A1DB2790-0D97-0BAB-C181-75E72F4BCC29}"/>
          </ac:spMkLst>
        </pc:spChg>
        <pc:spChg chg="del">
          <ac:chgData name="Yan Zhao" userId="3b5aa489-47ea-468b-84f4-bfcef63c3ea6" providerId="ADAL" clId="{6E3AEEA6-7BC3-234E-985F-338BB0878DA6}" dt="2024-07-30T12:15:44.284" v="37" actId="21"/>
          <ac:spMkLst>
            <pc:docMk/>
            <pc:sldMk cId="3987769180" sldId="268"/>
            <ac:spMk id="4" creationId="{7C319519-E693-82BA-EBC0-D5DE08AD529F}"/>
          </ac:spMkLst>
        </pc:spChg>
        <pc:picChg chg="mod">
          <ac:chgData name="Yan Zhao" userId="3b5aa489-47ea-468b-84f4-bfcef63c3ea6" providerId="ADAL" clId="{6E3AEEA6-7BC3-234E-985F-338BB0878DA6}" dt="2024-07-30T12:15:50.832" v="40" actId="1076"/>
          <ac:picMkLst>
            <pc:docMk/>
            <pc:sldMk cId="3987769180" sldId="268"/>
            <ac:picMk id="3" creationId="{D05EF748-0E8B-CD8A-D024-6E21F6525C2B}"/>
          </ac:picMkLst>
        </pc:picChg>
      </pc:sldChg>
    </pc:docChg>
  </pc:docChgLst>
  <pc:docChgLst>
    <pc:chgData name="Yan Zhao" userId="3b5aa489-47ea-468b-84f4-bfcef63c3ea6" providerId="ADAL" clId="{FD5BBF45-B60D-AD42-ADBD-82EA113B7C16}"/>
    <pc:docChg chg="custSel modSld">
      <pc:chgData name="Yan Zhao" userId="3b5aa489-47ea-468b-84f4-bfcef63c3ea6" providerId="ADAL" clId="{FD5BBF45-B60D-AD42-ADBD-82EA113B7C16}" dt="2024-06-28T16:06:24.607" v="330"/>
      <pc:docMkLst>
        <pc:docMk/>
      </pc:docMkLst>
      <pc:sldChg chg="delSp modSp mod">
        <pc:chgData name="Yan Zhao" userId="3b5aa489-47ea-468b-84f4-bfcef63c3ea6" providerId="ADAL" clId="{FD5BBF45-B60D-AD42-ADBD-82EA113B7C16}" dt="2024-06-22T18:34:19.508" v="324" actId="1076"/>
        <pc:sldMkLst>
          <pc:docMk/>
          <pc:sldMk cId="1116375164" sldId="257"/>
        </pc:sldMkLst>
        <pc:spChg chg="del">
          <ac:chgData name="Yan Zhao" userId="3b5aa489-47ea-468b-84f4-bfcef63c3ea6" providerId="ADAL" clId="{FD5BBF45-B60D-AD42-ADBD-82EA113B7C16}" dt="2024-06-22T18:34:03.805" v="318" actId="478"/>
          <ac:spMkLst>
            <pc:docMk/>
            <pc:sldMk cId="1116375164" sldId="257"/>
            <ac:spMk id="6" creationId="{D3E48D0A-FD4E-662D-67D6-C5FD5C68A026}"/>
          </ac:spMkLst>
        </pc:spChg>
        <pc:spChg chg="del">
          <ac:chgData name="Yan Zhao" userId="3b5aa489-47ea-468b-84f4-bfcef63c3ea6" providerId="ADAL" clId="{FD5BBF45-B60D-AD42-ADBD-82EA113B7C16}" dt="2024-06-22T18:33:58.157" v="317" actId="478"/>
          <ac:spMkLst>
            <pc:docMk/>
            <pc:sldMk cId="1116375164" sldId="257"/>
            <ac:spMk id="8" creationId="{71F6DD1A-182F-7ABC-E023-520C2CC06034}"/>
          </ac:spMkLst>
        </pc:spChg>
        <pc:picChg chg="mod">
          <ac:chgData name="Yan Zhao" userId="3b5aa489-47ea-468b-84f4-bfcef63c3ea6" providerId="ADAL" clId="{FD5BBF45-B60D-AD42-ADBD-82EA113B7C16}" dt="2024-06-22T18:34:19.508" v="324" actId="1076"/>
          <ac:picMkLst>
            <pc:docMk/>
            <pc:sldMk cId="1116375164" sldId="257"/>
            <ac:picMk id="4" creationId="{67B7B23D-B742-FAAC-A8FA-C0ADB3B65767}"/>
          </ac:picMkLst>
        </pc:picChg>
        <pc:picChg chg="del">
          <ac:chgData name="Yan Zhao" userId="3b5aa489-47ea-468b-84f4-bfcef63c3ea6" providerId="ADAL" clId="{FD5BBF45-B60D-AD42-ADBD-82EA113B7C16}" dt="2024-06-22T18:33:58.157" v="317" actId="478"/>
          <ac:picMkLst>
            <pc:docMk/>
            <pc:sldMk cId="1116375164" sldId="257"/>
            <ac:picMk id="9" creationId="{32A4A76E-4FA9-7085-4689-ECA5B4AE8882}"/>
          </ac:picMkLst>
        </pc:picChg>
        <pc:picChg chg="del">
          <ac:chgData name="Yan Zhao" userId="3b5aa489-47ea-468b-84f4-bfcef63c3ea6" providerId="ADAL" clId="{FD5BBF45-B60D-AD42-ADBD-82EA113B7C16}" dt="2024-06-22T18:33:58.157" v="317" actId="478"/>
          <ac:picMkLst>
            <pc:docMk/>
            <pc:sldMk cId="1116375164" sldId="257"/>
            <ac:picMk id="27" creationId="{04297B1E-CE25-CA3E-C6DD-954B1B5F7116}"/>
          </ac:picMkLst>
        </pc:picChg>
      </pc:sldChg>
      <pc:sldChg chg="addSp delSp modSp mod">
        <pc:chgData name="Yan Zhao" userId="3b5aa489-47ea-468b-84f4-bfcef63c3ea6" providerId="ADAL" clId="{FD5BBF45-B60D-AD42-ADBD-82EA113B7C16}" dt="2024-06-20T15:11:46.350" v="114" actId="1076"/>
        <pc:sldMkLst>
          <pc:docMk/>
          <pc:sldMk cId="2903892845" sldId="259"/>
        </pc:sldMkLst>
        <pc:picChg chg="del">
          <ac:chgData name="Yan Zhao" userId="3b5aa489-47ea-468b-84f4-bfcef63c3ea6" providerId="ADAL" clId="{FD5BBF45-B60D-AD42-ADBD-82EA113B7C16}" dt="2024-06-19T22:03:02.347" v="19" actId="478"/>
          <ac:picMkLst>
            <pc:docMk/>
            <pc:sldMk cId="2903892845" sldId="259"/>
            <ac:picMk id="2" creationId="{9C498391-3A5F-8E6F-7A31-CC8DDCF7A062}"/>
          </ac:picMkLst>
        </pc:picChg>
        <pc:picChg chg="add mod">
          <ac:chgData name="Yan Zhao" userId="3b5aa489-47ea-468b-84f4-bfcef63c3ea6" providerId="ADAL" clId="{FD5BBF45-B60D-AD42-ADBD-82EA113B7C16}" dt="2024-06-20T15:11:46.350" v="114" actId="1076"/>
          <ac:picMkLst>
            <pc:docMk/>
            <pc:sldMk cId="2903892845" sldId="259"/>
            <ac:picMk id="5" creationId="{07AF622F-AA62-2C09-48E0-8915F8D106E8}"/>
          </ac:picMkLst>
        </pc:picChg>
      </pc:sldChg>
      <pc:sldChg chg="addSp delSp modSp mod">
        <pc:chgData name="Yan Zhao" userId="3b5aa489-47ea-468b-84f4-bfcef63c3ea6" providerId="ADAL" clId="{FD5BBF45-B60D-AD42-ADBD-82EA113B7C16}" dt="2024-06-23T20:57:34.715" v="326" actId="478"/>
        <pc:sldMkLst>
          <pc:docMk/>
          <pc:sldMk cId="3351872524" sldId="264"/>
        </pc:sldMkLst>
        <pc:spChg chg="del mod">
          <ac:chgData name="Yan Zhao" userId="3b5aa489-47ea-468b-84f4-bfcef63c3ea6" providerId="ADAL" clId="{FD5BBF45-B60D-AD42-ADBD-82EA113B7C16}" dt="2024-06-19T22:08:57.814" v="69" actId="478"/>
          <ac:spMkLst>
            <pc:docMk/>
            <pc:sldMk cId="3351872524" sldId="264"/>
            <ac:spMk id="3" creationId="{E34617F3-476A-1CFE-1990-16568920F6D8}"/>
          </ac:spMkLst>
        </pc:spChg>
        <pc:spChg chg="mod">
          <ac:chgData name="Yan Zhao" userId="3b5aa489-47ea-468b-84f4-bfcef63c3ea6" providerId="ADAL" clId="{FD5BBF45-B60D-AD42-ADBD-82EA113B7C16}" dt="2024-06-19T22:11:53.072" v="113" actId="12788"/>
          <ac:spMkLst>
            <pc:docMk/>
            <pc:sldMk cId="3351872524" sldId="264"/>
            <ac:spMk id="4" creationId="{61906F06-18EB-5640-782C-D1BDC24CF039}"/>
          </ac:spMkLst>
        </pc:spChg>
        <pc:spChg chg="mod">
          <ac:chgData name="Yan Zhao" userId="3b5aa489-47ea-468b-84f4-bfcef63c3ea6" providerId="ADAL" clId="{FD5BBF45-B60D-AD42-ADBD-82EA113B7C16}" dt="2024-06-19T22:11:53.072" v="113" actId="12788"/>
          <ac:spMkLst>
            <pc:docMk/>
            <pc:sldMk cId="3351872524" sldId="264"/>
            <ac:spMk id="9" creationId="{92DFF016-C66A-DB72-DD2D-F45755C209CB}"/>
          </ac:spMkLst>
        </pc:spChg>
        <pc:spChg chg="mod">
          <ac:chgData name="Yan Zhao" userId="3b5aa489-47ea-468b-84f4-bfcef63c3ea6" providerId="ADAL" clId="{FD5BBF45-B60D-AD42-ADBD-82EA113B7C16}" dt="2024-06-19T22:11:44.802" v="112" actId="12788"/>
          <ac:spMkLst>
            <pc:docMk/>
            <pc:sldMk cId="3351872524" sldId="264"/>
            <ac:spMk id="15" creationId="{DADB8A5C-66A0-CDF8-227D-E8636C185137}"/>
          </ac:spMkLst>
        </pc:spChg>
        <pc:spChg chg="mod">
          <ac:chgData name="Yan Zhao" userId="3b5aa489-47ea-468b-84f4-bfcef63c3ea6" providerId="ADAL" clId="{FD5BBF45-B60D-AD42-ADBD-82EA113B7C16}" dt="2024-06-19T22:11:44.802" v="112" actId="12788"/>
          <ac:spMkLst>
            <pc:docMk/>
            <pc:sldMk cId="3351872524" sldId="264"/>
            <ac:spMk id="18" creationId="{FDDC629D-81D5-A2CE-084B-668A27E96833}"/>
          </ac:spMkLst>
        </pc:spChg>
        <pc:spChg chg="mod">
          <ac:chgData name="Yan Zhao" userId="3b5aa489-47ea-468b-84f4-bfcef63c3ea6" providerId="ADAL" clId="{FD5BBF45-B60D-AD42-ADBD-82EA113B7C16}" dt="2024-06-19T22:11:44.802" v="112" actId="12788"/>
          <ac:spMkLst>
            <pc:docMk/>
            <pc:sldMk cId="3351872524" sldId="264"/>
            <ac:spMk id="19" creationId="{CE4B57A4-D9F6-2AFF-B0B7-89E3DC7ADCA3}"/>
          </ac:spMkLst>
        </pc:spChg>
        <pc:spChg chg="del">
          <ac:chgData name="Yan Zhao" userId="3b5aa489-47ea-468b-84f4-bfcef63c3ea6" providerId="ADAL" clId="{FD5BBF45-B60D-AD42-ADBD-82EA113B7C16}" dt="2024-06-23T20:57:34.715" v="326" actId="478"/>
          <ac:spMkLst>
            <pc:docMk/>
            <pc:sldMk cId="3351872524" sldId="264"/>
            <ac:spMk id="23" creationId="{3FD1B32C-704B-B26B-B3C8-D814EE63C522}"/>
          </ac:spMkLst>
        </pc:spChg>
        <pc:spChg chg="del mod">
          <ac:chgData name="Yan Zhao" userId="3b5aa489-47ea-468b-84f4-bfcef63c3ea6" providerId="ADAL" clId="{FD5BBF45-B60D-AD42-ADBD-82EA113B7C16}" dt="2024-06-23T20:57:33.372" v="325" actId="478"/>
          <ac:spMkLst>
            <pc:docMk/>
            <pc:sldMk cId="3351872524" sldId="264"/>
            <ac:spMk id="24" creationId="{53B689EF-4C76-960A-8B77-2C63BA926299}"/>
          </ac:spMkLst>
        </pc:spChg>
        <pc:spChg chg="add mod">
          <ac:chgData name="Yan Zhao" userId="3b5aa489-47ea-468b-84f4-bfcef63c3ea6" providerId="ADAL" clId="{FD5BBF45-B60D-AD42-ADBD-82EA113B7C16}" dt="2024-06-19T22:11:53.072" v="113" actId="12788"/>
          <ac:spMkLst>
            <pc:docMk/>
            <pc:sldMk cId="3351872524" sldId="264"/>
            <ac:spMk id="29" creationId="{75B6C0AE-ECA9-3332-A6E2-BAF10EDB530A}"/>
          </ac:spMkLst>
        </pc:spChg>
        <pc:picChg chg="del">
          <ac:chgData name="Yan Zhao" userId="3b5aa489-47ea-468b-84f4-bfcef63c3ea6" providerId="ADAL" clId="{FD5BBF45-B60D-AD42-ADBD-82EA113B7C16}" dt="2024-06-19T22:06:21.072" v="24" actId="478"/>
          <ac:picMkLst>
            <pc:docMk/>
            <pc:sldMk cId="3351872524" sldId="264"/>
            <ac:picMk id="2" creationId="{DEA39A4E-7462-58F9-87E6-C3A4D0CD5DBF}"/>
          </ac:picMkLst>
        </pc:picChg>
        <pc:picChg chg="add del mod">
          <ac:chgData name="Yan Zhao" userId="3b5aa489-47ea-468b-84f4-bfcef63c3ea6" providerId="ADAL" clId="{FD5BBF45-B60D-AD42-ADBD-82EA113B7C16}" dt="2024-06-21T14:41:11.588" v="307" actId="21"/>
          <ac:picMkLst>
            <pc:docMk/>
            <pc:sldMk cId="3351872524" sldId="264"/>
            <ac:picMk id="3" creationId="{9E532CE6-C29D-7C69-ADBA-3875AD306E8D}"/>
          </ac:picMkLst>
        </pc:picChg>
        <pc:picChg chg="del">
          <ac:chgData name="Yan Zhao" userId="3b5aa489-47ea-468b-84f4-bfcef63c3ea6" providerId="ADAL" clId="{FD5BBF45-B60D-AD42-ADBD-82EA113B7C16}" dt="2024-06-19T22:06:18.449" v="22" actId="478"/>
          <ac:picMkLst>
            <pc:docMk/>
            <pc:sldMk cId="3351872524" sldId="264"/>
            <ac:picMk id="5" creationId="{F0D76EC9-5DA3-B944-E782-91846DDF293F}"/>
          </ac:picMkLst>
        </pc:picChg>
        <pc:picChg chg="add del mod">
          <ac:chgData name="Yan Zhao" userId="3b5aa489-47ea-468b-84f4-bfcef63c3ea6" providerId="ADAL" clId="{FD5BBF45-B60D-AD42-ADBD-82EA113B7C16}" dt="2024-06-21T14:41:11.588" v="307" actId="21"/>
          <ac:picMkLst>
            <pc:docMk/>
            <pc:sldMk cId="3351872524" sldId="264"/>
            <ac:picMk id="6" creationId="{92E2AC12-C6E1-3841-23D1-51C273E00A0F}"/>
          </ac:picMkLst>
        </pc:picChg>
        <pc:picChg chg="del">
          <ac:chgData name="Yan Zhao" userId="3b5aa489-47ea-468b-84f4-bfcef63c3ea6" providerId="ADAL" clId="{FD5BBF45-B60D-AD42-ADBD-82EA113B7C16}" dt="2024-06-19T22:06:19.755" v="23" actId="478"/>
          <ac:picMkLst>
            <pc:docMk/>
            <pc:sldMk cId="3351872524" sldId="264"/>
            <ac:picMk id="7" creationId="{B7362714-A31D-7B84-E53A-24E260474E9C}"/>
          </ac:picMkLst>
        </pc:picChg>
        <pc:picChg chg="add mod">
          <ac:chgData name="Yan Zhao" userId="3b5aa489-47ea-468b-84f4-bfcef63c3ea6" providerId="ADAL" clId="{FD5BBF45-B60D-AD42-ADBD-82EA113B7C16}" dt="2024-06-19T22:11:53.072" v="113" actId="12788"/>
          <ac:picMkLst>
            <pc:docMk/>
            <pc:sldMk cId="3351872524" sldId="264"/>
            <ac:picMk id="8" creationId="{9F3DAC96-4CD1-956C-C4EA-FC753933D894}"/>
          </ac:picMkLst>
        </pc:picChg>
        <pc:picChg chg="del">
          <ac:chgData name="Yan Zhao" userId="3b5aa489-47ea-468b-84f4-bfcef63c3ea6" providerId="ADAL" clId="{FD5BBF45-B60D-AD42-ADBD-82EA113B7C16}" dt="2024-06-19T22:06:17.082" v="21" actId="478"/>
          <ac:picMkLst>
            <pc:docMk/>
            <pc:sldMk cId="3351872524" sldId="264"/>
            <ac:picMk id="10" creationId="{470108E5-04D6-992D-B3B0-31BE21952016}"/>
          </ac:picMkLst>
        </pc:picChg>
        <pc:picChg chg="del">
          <ac:chgData name="Yan Zhao" userId="3b5aa489-47ea-468b-84f4-bfcef63c3ea6" providerId="ADAL" clId="{FD5BBF45-B60D-AD42-ADBD-82EA113B7C16}" dt="2024-06-19T22:06:17.082" v="21" actId="478"/>
          <ac:picMkLst>
            <pc:docMk/>
            <pc:sldMk cId="3351872524" sldId="264"/>
            <ac:picMk id="12" creationId="{60F92F98-5DB7-FDD6-03AA-EC5A84BA92B2}"/>
          </ac:picMkLst>
        </pc:picChg>
        <pc:picChg chg="add mod">
          <ac:chgData name="Yan Zhao" userId="3b5aa489-47ea-468b-84f4-bfcef63c3ea6" providerId="ADAL" clId="{FD5BBF45-B60D-AD42-ADBD-82EA113B7C16}" dt="2024-06-19T22:11:44.802" v="112" actId="12788"/>
          <ac:picMkLst>
            <pc:docMk/>
            <pc:sldMk cId="3351872524" sldId="264"/>
            <ac:picMk id="13" creationId="{E6198D88-8749-830D-0904-C025CF92FBD0}"/>
          </ac:picMkLst>
        </pc:picChg>
        <pc:picChg chg="del">
          <ac:chgData name="Yan Zhao" userId="3b5aa489-47ea-468b-84f4-bfcef63c3ea6" providerId="ADAL" clId="{FD5BBF45-B60D-AD42-ADBD-82EA113B7C16}" dt="2024-06-19T22:06:21.904" v="25" actId="478"/>
          <ac:picMkLst>
            <pc:docMk/>
            <pc:sldMk cId="3351872524" sldId="264"/>
            <ac:picMk id="14" creationId="{3298D460-BB82-3086-660B-C3D049DBC393}"/>
          </ac:picMkLst>
        </pc:picChg>
        <pc:picChg chg="add mod modCrop">
          <ac:chgData name="Yan Zhao" userId="3b5aa489-47ea-468b-84f4-bfcef63c3ea6" providerId="ADAL" clId="{FD5BBF45-B60D-AD42-ADBD-82EA113B7C16}" dt="2024-06-19T22:11:53.072" v="113" actId="12788"/>
          <ac:picMkLst>
            <pc:docMk/>
            <pc:sldMk cId="3351872524" sldId="264"/>
            <ac:picMk id="17" creationId="{66B4217C-108E-4881-0AA8-23A6A4032BAE}"/>
          </ac:picMkLst>
        </pc:picChg>
        <pc:picChg chg="del">
          <ac:chgData name="Yan Zhao" userId="3b5aa489-47ea-468b-84f4-bfcef63c3ea6" providerId="ADAL" clId="{FD5BBF45-B60D-AD42-ADBD-82EA113B7C16}" dt="2024-06-19T22:09:19.120" v="76" actId="478"/>
          <ac:picMkLst>
            <pc:docMk/>
            <pc:sldMk cId="3351872524" sldId="264"/>
            <ac:picMk id="20" creationId="{1F555ED3-FB48-D942-B7A8-D8D6F44E56C9}"/>
          </ac:picMkLst>
        </pc:picChg>
        <pc:picChg chg="del">
          <ac:chgData name="Yan Zhao" userId="3b5aa489-47ea-468b-84f4-bfcef63c3ea6" providerId="ADAL" clId="{FD5BBF45-B60D-AD42-ADBD-82EA113B7C16}" dt="2024-06-19T22:09:19.120" v="76" actId="478"/>
          <ac:picMkLst>
            <pc:docMk/>
            <pc:sldMk cId="3351872524" sldId="264"/>
            <ac:picMk id="21" creationId="{0D7D2C61-3280-9D88-0B27-3F4C7AC62655}"/>
          </ac:picMkLst>
        </pc:picChg>
        <pc:picChg chg="add mod modCrop">
          <ac:chgData name="Yan Zhao" userId="3b5aa489-47ea-468b-84f4-bfcef63c3ea6" providerId="ADAL" clId="{FD5BBF45-B60D-AD42-ADBD-82EA113B7C16}" dt="2024-06-19T22:11:44.802" v="112" actId="12788"/>
          <ac:picMkLst>
            <pc:docMk/>
            <pc:sldMk cId="3351872524" sldId="264"/>
            <ac:picMk id="26" creationId="{DEF457F7-6A47-B8CE-23FA-8226027E38C0}"/>
          </ac:picMkLst>
        </pc:picChg>
        <pc:picChg chg="add mod modCrop">
          <ac:chgData name="Yan Zhao" userId="3b5aa489-47ea-468b-84f4-bfcef63c3ea6" providerId="ADAL" clId="{FD5BBF45-B60D-AD42-ADBD-82EA113B7C16}" dt="2024-06-19T22:11:44.802" v="112" actId="12788"/>
          <ac:picMkLst>
            <pc:docMk/>
            <pc:sldMk cId="3351872524" sldId="264"/>
            <ac:picMk id="28" creationId="{B6F82CC9-0E99-6509-E4D5-E846FB77BB06}"/>
          </ac:picMkLst>
        </pc:picChg>
        <pc:picChg chg="add mod modCrop">
          <ac:chgData name="Yan Zhao" userId="3b5aa489-47ea-468b-84f4-bfcef63c3ea6" providerId="ADAL" clId="{FD5BBF45-B60D-AD42-ADBD-82EA113B7C16}" dt="2024-06-19T22:11:53.072" v="113" actId="12788"/>
          <ac:picMkLst>
            <pc:docMk/>
            <pc:sldMk cId="3351872524" sldId="264"/>
            <ac:picMk id="31" creationId="{77F19C0B-80BF-DA5E-B80A-916128A7DF98}"/>
          </ac:picMkLst>
        </pc:picChg>
      </pc:sldChg>
      <pc:sldChg chg="addSp delSp modSp mod">
        <pc:chgData name="Yan Zhao" userId="3b5aa489-47ea-468b-84f4-bfcef63c3ea6" providerId="ADAL" clId="{FD5BBF45-B60D-AD42-ADBD-82EA113B7C16}" dt="2024-06-20T16:43:01.149" v="230" actId="1076"/>
        <pc:sldMkLst>
          <pc:docMk/>
          <pc:sldMk cId="683148836" sldId="265"/>
        </pc:sldMkLst>
        <pc:picChg chg="add del mod">
          <ac:chgData name="Yan Zhao" userId="3b5aa489-47ea-468b-84f4-bfcef63c3ea6" providerId="ADAL" clId="{FD5BBF45-B60D-AD42-ADBD-82EA113B7C16}" dt="2024-06-20T16:42:46.324" v="224" actId="478"/>
          <ac:picMkLst>
            <pc:docMk/>
            <pc:sldMk cId="683148836" sldId="265"/>
            <ac:picMk id="3" creationId="{CEECEC71-BF91-64BB-213B-DF55ECC4F4AC}"/>
          </ac:picMkLst>
        </pc:picChg>
        <pc:picChg chg="del">
          <ac:chgData name="Yan Zhao" userId="3b5aa489-47ea-468b-84f4-bfcef63c3ea6" providerId="ADAL" clId="{FD5BBF45-B60D-AD42-ADBD-82EA113B7C16}" dt="2024-06-19T20:40:54.896" v="5" actId="478"/>
          <ac:picMkLst>
            <pc:docMk/>
            <pc:sldMk cId="683148836" sldId="265"/>
            <ac:picMk id="4" creationId="{2DAD92F4-C52B-7FD6-3CE5-71581230C4BC}"/>
          </ac:picMkLst>
        </pc:picChg>
        <pc:picChg chg="add mod modCrop">
          <ac:chgData name="Yan Zhao" userId="3b5aa489-47ea-468b-84f4-bfcef63c3ea6" providerId="ADAL" clId="{FD5BBF45-B60D-AD42-ADBD-82EA113B7C16}" dt="2024-06-20T16:43:01.149" v="230" actId="1076"/>
          <ac:picMkLst>
            <pc:docMk/>
            <pc:sldMk cId="683148836" sldId="265"/>
            <ac:picMk id="4" creationId="{F9D1B36A-8C51-3F26-92A6-A18588049CDB}"/>
          </ac:picMkLst>
        </pc:picChg>
      </pc:sldChg>
      <pc:sldChg chg="addSp delSp modSp mod">
        <pc:chgData name="Yan Zhao" userId="3b5aa489-47ea-468b-84f4-bfcef63c3ea6" providerId="ADAL" clId="{FD5BBF45-B60D-AD42-ADBD-82EA113B7C16}" dt="2024-06-20T20:59:33.892" v="282" actId="20577"/>
        <pc:sldMkLst>
          <pc:docMk/>
          <pc:sldMk cId="2976955891" sldId="267"/>
        </pc:sldMkLst>
        <pc:spChg chg="add mod">
          <ac:chgData name="Yan Zhao" userId="3b5aa489-47ea-468b-84f4-bfcef63c3ea6" providerId="ADAL" clId="{FD5BBF45-B60D-AD42-ADBD-82EA113B7C16}" dt="2024-06-20T20:59:33.892" v="282" actId="20577"/>
          <ac:spMkLst>
            <pc:docMk/>
            <pc:sldMk cId="2976955891" sldId="267"/>
            <ac:spMk id="2" creationId="{0DB3AD95-C027-02B9-D35A-015A76E7EB74}"/>
          </ac:spMkLst>
        </pc:spChg>
        <pc:spChg chg="del">
          <ac:chgData name="Yan Zhao" userId="3b5aa489-47ea-468b-84f4-bfcef63c3ea6" providerId="ADAL" clId="{FD5BBF45-B60D-AD42-ADBD-82EA113B7C16}" dt="2024-06-20T16:26:17.614" v="198" actId="478"/>
          <ac:spMkLst>
            <pc:docMk/>
            <pc:sldMk cId="2976955891" sldId="267"/>
            <ac:spMk id="5" creationId="{7D856276-2EC8-61D4-3494-15D24A1B6DFD}"/>
          </ac:spMkLst>
        </pc:sp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3" creationId="{7B87372D-4561-0C2B-4E3C-E310B91C7ECD}"/>
          </ac:picMkLst>
        </pc:picChg>
        <pc:picChg chg="del">
          <ac:chgData name="Yan Zhao" userId="3b5aa489-47ea-468b-84f4-bfcef63c3ea6" providerId="ADAL" clId="{FD5BBF45-B60D-AD42-ADBD-82EA113B7C16}" dt="2024-06-19T20:41:18.733" v="8" actId="478"/>
          <ac:picMkLst>
            <pc:docMk/>
            <pc:sldMk cId="2976955891" sldId="267"/>
            <ac:picMk id="3" creationId="{AA50BA16-1E3C-2BDF-028C-8EB619A3A24C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4" creationId="{E0949C02-9C6A-CD42-8E51-CBE1FDF2AA03}"/>
          </ac:picMkLst>
        </pc:picChg>
        <pc:picChg chg="del">
          <ac:chgData name="Yan Zhao" userId="3b5aa489-47ea-468b-84f4-bfcef63c3ea6" providerId="ADAL" clId="{FD5BBF45-B60D-AD42-ADBD-82EA113B7C16}" dt="2024-06-19T20:41:18.733" v="8" actId="478"/>
          <ac:picMkLst>
            <pc:docMk/>
            <pc:sldMk cId="2976955891" sldId="267"/>
            <ac:picMk id="4" creationId="{FFED1D9F-14C2-257E-5D72-E587C67372EF}"/>
          </ac:picMkLst>
        </pc:picChg>
        <pc:picChg chg="del">
          <ac:chgData name="Yan Zhao" userId="3b5aa489-47ea-468b-84f4-bfcef63c3ea6" providerId="ADAL" clId="{FD5BBF45-B60D-AD42-ADBD-82EA113B7C16}" dt="2024-06-19T20:41:18.733" v="8" actId="478"/>
          <ac:picMkLst>
            <pc:docMk/>
            <pc:sldMk cId="2976955891" sldId="267"/>
            <ac:picMk id="6" creationId="{4A252A85-1C52-5C51-B812-5B10B8A84D01}"/>
          </ac:picMkLst>
        </pc:pic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6" creationId="{AD9E2384-AA0B-6E31-D9DF-F75A6F3F6653}"/>
          </ac:picMkLst>
        </pc:picChg>
        <pc:picChg chg="del">
          <ac:chgData name="Yan Zhao" userId="3b5aa489-47ea-468b-84f4-bfcef63c3ea6" providerId="ADAL" clId="{FD5BBF45-B60D-AD42-ADBD-82EA113B7C16}" dt="2024-06-20T15:12:44.183" v="121" actId="478"/>
          <ac:picMkLst>
            <pc:docMk/>
            <pc:sldMk cId="2976955891" sldId="267"/>
            <ac:picMk id="7" creationId="{A7131832-B479-C19B-CB0D-FE2E6272CDCF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8" creationId="{2D413211-2D2B-90AA-63D7-4221C8B938A4}"/>
          </ac:picMkLst>
        </pc:picChg>
        <pc:picChg chg="del">
          <ac:chgData name="Yan Zhao" userId="3b5aa489-47ea-468b-84f4-bfcef63c3ea6" providerId="ADAL" clId="{FD5BBF45-B60D-AD42-ADBD-82EA113B7C16}" dt="2024-06-19T20:41:18.733" v="8" actId="478"/>
          <ac:picMkLst>
            <pc:docMk/>
            <pc:sldMk cId="2976955891" sldId="267"/>
            <ac:picMk id="8" creationId="{B314C09E-1484-5B70-95AF-CDFC4223C272}"/>
          </ac:picMkLst>
        </pc:pic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9" creationId="{8F851FD5-6BA9-CCF1-3EA7-A74F5C582B4F}"/>
          </ac:picMkLst>
        </pc:pic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11" creationId="{7793D1BE-DF22-C43F-6113-D84B9A6ABAF6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12" creationId="{25AB965F-979B-DC28-C824-DFC9EB5CAAC8}"/>
          </ac:picMkLst>
        </pc:pic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13" creationId="{FB6CAC30-B394-4BAF-F42F-142F2E159A98}"/>
          </ac:picMkLst>
        </pc:picChg>
        <pc:picChg chg="add del mod">
          <ac:chgData name="Yan Zhao" userId="3b5aa489-47ea-468b-84f4-bfcef63c3ea6" providerId="ADAL" clId="{FD5BBF45-B60D-AD42-ADBD-82EA113B7C16}" dt="2024-06-20T16:26:17.614" v="198" actId="478"/>
          <ac:picMkLst>
            <pc:docMk/>
            <pc:sldMk cId="2976955891" sldId="267"/>
            <ac:picMk id="15" creationId="{6792CDD1-6253-7B1E-C38B-2F55F4C63FE4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16" creationId="{88F8CBA9-BCB9-A8AC-308D-8BDEDF1023FF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18" creationId="{5B80552A-266A-E0EB-A076-175B87123833}"/>
          </ac:picMkLst>
        </pc:picChg>
        <pc:picChg chg="add mod">
          <ac:chgData name="Yan Zhao" userId="3b5aa489-47ea-468b-84f4-bfcef63c3ea6" providerId="ADAL" clId="{FD5BBF45-B60D-AD42-ADBD-82EA113B7C16}" dt="2024-06-20T20:59:20.315" v="279" actId="1076"/>
          <ac:picMkLst>
            <pc:docMk/>
            <pc:sldMk cId="2976955891" sldId="267"/>
            <ac:picMk id="20" creationId="{BFF659B6-A011-7D04-A00A-AC3675EF03FA}"/>
          </ac:picMkLst>
        </pc:picChg>
      </pc:sldChg>
      <pc:sldChg chg="addSp delSp modSp mod">
        <pc:chgData name="Yan Zhao" userId="3b5aa489-47ea-468b-84f4-bfcef63c3ea6" providerId="ADAL" clId="{FD5BBF45-B60D-AD42-ADBD-82EA113B7C16}" dt="2024-06-28T16:06:24.607" v="330"/>
        <pc:sldMkLst>
          <pc:docMk/>
          <pc:sldMk cId="3987769180" sldId="268"/>
        </pc:sldMkLst>
        <pc:spChg chg="add del mod">
          <ac:chgData name="Yan Zhao" userId="3b5aa489-47ea-468b-84f4-bfcef63c3ea6" providerId="ADAL" clId="{FD5BBF45-B60D-AD42-ADBD-82EA113B7C16}" dt="2024-06-28T16:06:24.607" v="330"/>
          <ac:spMkLst>
            <pc:docMk/>
            <pc:sldMk cId="3987769180" sldId="268"/>
            <ac:spMk id="2" creationId="{99A417B0-31DF-3DC0-9A45-691D3C74C39F}"/>
          </ac:spMkLst>
        </pc:spChg>
        <pc:picChg chg="add mod modCrop">
          <ac:chgData name="Yan Zhao" userId="3b5aa489-47ea-468b-84f4-bfcef63c3ea6" providerId="ADAL" clId="{FD5BBF45-B60D-AD42-ADBD-82EA113B7C16}" dt="2024-06-24T18:39:25.501" v="327" actId="1076"/>
          <ac:picMkLst>
            <pc:docMk/>
            <pc:sldMk cId="3987769180" sldId="268"/>
            <ac:picMk id="3" creationId="{D05EF748-0E8B-CD8A-D024-6E21F6525C2B}"/>
          </ac:picMkLst>
        </pc:picChg>
        <pc:picChg chg="del mod">
          <ac:chgData name="Yan Zhao" userId="3b5aa489-47ea-468b-84f4-bfcef63c3ea6" providerId="ADAL" clId="{FD5BBF45-B60D-AD42-ADBD-82EA113B7C16}" dt="2024-06-19T21:44:24.446" v="14" actId="478"/>
          <ac:picMkLst>
            <pc:docMk/>
            <pc:sldMk cId="3987769180" sldId="268"/>
            <ac:picMk id="3" creationId="{E6804CED-225C-A19C-20EA-F13F16490912}"/>
          </ac:picMkLst>
        </pc:picChg>
        <pc:picChg chg="add del mod">
          <ac:chgData name="Yan Zhao" userId="3b5aa489-47ea-468b-84f4-bfcef63c3ea6" providerId="ADAL" clId="{FD5BBF45-B60D-AD42-ADBD-82EA113B7C16}" dt="2024-06-22T09:15:28.628" v="308" actId="478"/>
          <ac:picMkLst>
            <pc:docMk/>
            <pc:sldMk cId="3987769180" sldId="268"/>
            <ac:picMk id="5" creationId="{F71FDF9B-FBED-8DE5-B9D1-04B9AC93E107}"/>
          </ac:picMkLst>
        </pc:picChg>
      </pc:sldChg>
    </pc:docChg>
  </pc:docChgLst>
  <pc:docChgLst>
    <pc:chgData name="Yan Zhao" userId="3b5aa489-47ea-468b-84f4-bfcef63c3ea6" providerId="ADAL" clId="{3E3065F8-6E60-0A44-AA0D-07E7AC4049B0}"/>
    <pc:docChg chg="custSel modSld">
      <pc:chgData name="Yan Zhao" userId="3b5aa489-47ea-468b-84f4-bfcef63c3ea6" providerId="ADAL" clId="{3E3065F8-6E60-0A44-AA0D-07E7AC4049B0}" dt="2024-05-02T12:38:27.652" v="12" actId="478"/>
      <pc:docMkLst>
        <pc:docMk/>
      </pc:docMkLst>
      <pc:sldChg chg="addSp delSp modSp mod">
        <pc:chgData name="Yan Zhao" userId="3b5aa489-47ea-468b-84f4-bfcef63c3ea6" providerId="ADAL" clId="{3E3065F8-6E60-0A44-AA0D-07E7AC4049B0}" dt="2024-05-02T12:38:27.652" v="12" actId="478"/>
        <pc:sldMkLst>
          <pc:docMk/>
          <pc:sldMk cId="1116375164" sldId="257"/>
        </pc:sldMkLst>
        <pc:spChg chg="add del mod">
          <ac:chgData name="Yan Zhao" userId="3b5aa489-47ea-468b-84f4-bfcef63c3ea6" providerId="ADAL" clId="{3E3065F8-6E60-0A44-AA0D-07E7AC4049B0}" dt="2024-05-02T12:38:27.652" v="12" actId="478"/>
          <ac:spMkLst>
            <pc:docMk/>
            <pc:sldMk cId="1116375164" sldId="257"/>
            <ac:spMk id="3" creationId="{37F89984-0B3D-BACF-B1FD-3B68BE65F6EC}"/>
          </ac:spMkLst>
        </pc:spChg>
        <pc:spChg chg="add del mod">
          <ac:chgData name="Yan Zhao" userId="3b5aa489-47ea-468b-84f4-bfcef63c3ea6" providerId="ADAL" clId="{3E3065F8-6E60-0A44-AA0D-07E7AC4049B0}" dt="2024-05-02T12:38:27.652" v="12" actId="478"/>
          <ac:spMkLst>
            <pc:docMk/>
            <pc:sldMk cId="1116375164" sldId="257"/>
            <ac:spMk id="6" creationId="{21747ADB-5BD5-8601-44D4-A6502F97AA8F}"/>
          </ac:spMkLst>
        </pc:spChg>
        <pc:picChg chg="add del mod">
          <ac:chgData name="Yan Zhao" userId="3b5aa489-47ea-468b-84f4-bfcef63c3ea6" providerId="ADAL" clId="{3E3065F8-6E60-0A44-AA0D-07E7AC4049B0}" dt="2024-05-02T12:38:27.652" v="12" actId="478"/>
          <ac:picMkLst>
            <pc:docMk/>
            <pc:sldMk cId="1116375164" sldId="257"/>
            <ac:picMk id="2" creationId="{A6DF86DD-DF3C-6EDB-96D1-C900AE8EAFFD}"/>
          </ac:picMkLst>
        </pc:picChg>
        <pc:picChg chg="add del mod">
          <ac:chgData name="Yan Zhao" userId="3b5aa489-47ea-468b-84f4-bfcef63c3ea6" providerId="ADAL" clId="{3E3065F8-6E60-0A44-AA0D-07E7AC4049B0}" dt="2024-05-02T12:38:27.652" v="12" actId="478"/>
          <ac:picMkLst>
            <pc:docMk/>
            <pc:sldMk cId="1116375164" sldId="257"/>
            <ac:picMk id="4" creationId="{AD387F2B-97FB-1C1D-5A84-17589DBFE98C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A2F231-AAEF-1047-8EEE-0D8C1C6CEA77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48FF0D-AFEB-B54F-8964-E57EB49BF1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776442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8FF0D-AFEB-B54F-8964-E57EB49BF126}" type="slidenum">
              <a:rPr kumimoji="1" lang="zh-CN" altLang="en-US" smtClean="0"/>
              <a:t>5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100707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8FF0D-AFEB-B54F-8964-E57EB49BF126}" type="slidenum">
              <a:rPr kumimoji="1" lang="zh-CN" altLang="en-US" smtClean="0"/>
              <a:t>6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81011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20193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1702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01052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17439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28676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312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10588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05163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422256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13961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39102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38551-430F-3244-A109-CCAE85C9CB2B}" type="datetimeFigureOut">
              <a:rPr kumimoji="1" lang="zh-CN" altLang="en-US" smtClean="0"/>
              <a:t>2024/7/30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67DB96-86E5-4A4A-9297-8D189420E14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0973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11.jpg"/><Relationship Id="rId7" Type="http://schemas.openxmlformats.org/officeDocument/2006/relationships/image" Target="../media/image15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表, 树状图&#10;&#10;描述已自动生成">
            <a:extLst>
              <a:ext uri="{FF2B5EF4-FFF2-40B4-BE49-F238E27FC236}">
                <a16:creationId xmlns:a16="http://schemas.microsoft.com/office/drawing/2014/main" id="{67B7B23D-B742-FAAC-A8FA-C0ADB3B657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119" y="369332"/>
            <a:ext cx="6617762" cy="529420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1E8C629-A79E-75C1-B936-0B3153ECFEFD}"/>
              </a:ext>
            </a:extLst>
          </p:cNvPr>
          <p:cNvSpPr txBox="1"/>
          <p:nvPr/>
        </p:nvSpPr>
        <p:spPr>
          <a:xfrm>
            <a:off x="120119" y="5463881"/>
            <a:ext cx="6443714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" altLang="zh-CN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Comparison of aneuploidy levels between biparental diploid blastomeres and blastomeres with WG abnormalities from normal and </a:t>
            </a:r>
            <a:r>
              <a:rPr lang="en" altLang="zh-CN" sz="10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terogoneic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ivisions.</a:t>
            </a:r>
            <a:r>
              <a:rPr lang="en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first cleavage pattern is indicated by words in the brackets: "Normal" denotes zygotes that cleaved without WG segregation errors, while "</a:t>
            </a:r>
            <a:r>
              <a:rPr lang="en" altLang="zh-CN" sz="10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eterogoneic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" refers to zygotes that cleaved with WG segregation errors. Aneuploidy levels were classified by % aneuploid autosomal regions. Euploid: &lt;=1%; Low: 1-5%; Medium: 5-10%; High: &gt;10%. Only blastomeres from the 31 fully examined embryos with inferred first cleavage patterns were included in this analysis.</a:t>
            </a:r>
          </a:p>
          <a:p>
            <a:pPr algn="just"/>
            <a:r>
              <a:rPr lang="en-US" altLang="zh-CN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63751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示&#10;&#10;描述已自动生成">
            <a:extLst>
              <a:ext uri="{FF2B5EF4-FFF2-40B4-BE49-F238E27FC236}">
                <a16:creationId xmlns:a16="http://schemas.microsoft.com/office/drawing/2014/main" id="{07AF622F-AA62-2C09-48E0-8915F8D106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4432"/>
            <a:ext cx="6858000" cy="4572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C1A9C47-5920-04F9-0D73-106ED505A8A1}"/>
              </a:ext>
            </a:extLst>
          </p:cNvPr>
          <p:cNvSpPr txBox="1"/>
          <p:nvPr/>
        </p:nvSpPr>
        <p:spPr>
          <a:xfrm>
            <a:off x="77972" y="5106432"/>
            <a:ext cx="662448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" altLang="zh-CN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High percentages of mitochondrial transcripts in cells from blastocysts.</a:t>
            </a:r>
          </a:p>
        </p:txBody>
      </p:sp>
    </p:spTree>
    <p:extLst>
      <p:ext uri="{BB962C8B-B14F-4D97-AF65-F5344CB8AC3E}">
        <p14:creationId xmlns:p14="http://schemas.microsoft.com/office/powerpoint/2010/main" val="29038928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, 条形图&#10;&#10;描述已自动生成">
            <a:extLst>
              <a:ext uri="{FF2B5EF4-FFF2-40B4-BE49-F238E27FC236}">
                <a16:creationId xmlns:a16="http://schemas.microsoft.com/office/drawing/2014/main" id="{D05EF748-0E8B-CD8A-D024-6E21F6525C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98" t="5138" b="1895"/>
          <a:stretch/>
        </p:blipFill>
        <p:spPr>
          <a:xfrm>
            <a:off x="564243" y="0"/>
            <a:ext cx="6293757" cy="920931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1DB2790-0D97-0BAB-C181-75E72F4BCC29}"/>
              </a:ext>
            </a:extLst>
          </p:cNvPr>
          <p:cNvSpPr txBox="1"/>
          <p:nvPr/>
        </p:nvSpPr>
        <p:spPr>
          <a:xfrm>
            <a:off x="199636" y="9137771"/>
            <a:ext cx="665836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" altLang="zh-CN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Genome constitution for cells from each molecular developmental stage and collection timepoint. </a:t>
            </a:r>
          </a:p>
        </p:txBody>
      </p:sp>
    </p:spTree>
    <p:extLst>
      <p:ext uri="{BB962C8B-B14F-4D97-AF65-F5344CB8AC3E}">
        <p14:creationId xmlns:p14="http://schemas.microsoft.com/office/powerpoint/2010/main" val="3987769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F9D1B36A-8C51-3F26-92A6-A18588049CD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449"/>
          <a:stretch/>
        </p:blipFill>
        <p:spPr>
          <a:xfrm>
            <a:off x="0" y="438150"/>
            <a:ext cx="6858000" cy="502285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69C9AB1-2DA8-36C9-7530-FEE48B75485A}"/>
              </a:ext>
            </a:extLst>
          </p:cNvPr>
          <p:cNvSpPr txBox="1"/>
          <p:nvPr/>
        </p:nvSpPr>
        <p:spPr>
          <a:xfrm>
            <a:off x="273376" y="5461000"/>
            <a:ext cx="633481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" altLang="zh-CN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Comparison of molecular age across collection timepoints for cells from outgrowths with comparable cell numbers.</a:t>
            </a:r>
          </a:p>
        </p:txBody>
      </p:sp>
    </p:spTree>
    <p:extLst>
      <p:ext uri="{BB962C8B-B14F-4D97-AF65-F5344CB8AC3E}">
        <p14:creationId xmlns:p14="http://schemas.microsoft.com/office/powerpoint/2010/main" val="683148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形用户界面&#10;&#10;中度可信度描述已自动生成">
            <a:extLst>
              <a:ext uri="{FF2B5EF4-FFF2-40B4-BE49-F238E27FC236}">
                <a16:creationId xmlns:a16="http://schemas.microsoft.com/office/drawing/2014/main" id="{E0949C02-9C6A-CD42-8E51-CBE1FDF2AA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88479" y="3332406"/>
            <a:ext cx="2971006" cy="2376805"/>
          </a:xfrm>
          <a:prstGeom prst="rect">
            <a:avLst/>
          </a:prstGeom>
        </p:spPr>
      </p:pic>
      <p:pic>
        <p:nvPicPr>
          <p:cNvPr id="8" name="图片 7" descr="图形用户界面, 应用程序, PowerPoint&#10;&#10;描述已自动生成">
            <a:extLst>
              <a:ext uri="{FF2B5EF4-FFF2-40B4-BE49-F238E27FC236}">
                <a16:creationId xmlns:a16="http://schemas.microsoft.com/office/drawing/2014/main" id="{2D413211-2D2B-90AA-63D7-4221C8B938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4078" y="5958924"/>
            <a:ext cx="2971006" cy="2376805"/>
          </a:xfrm>
          <a:prstGeom prst="rect">
            <a:avLst/>
          </a:prstGeom>
        </p:spPr>
      </p:pic>
      <p:pic>
        <p:nvPicPr>
          <p:cNvPr id="12" name="图片 11" descr="图形用户界面, 应用程序&#10;&#10;描述已自动生成">
            <a:extLst>
              <a:ext uri="{FF2B5EF4-FFF2-40B4-BE49-F238E27FC236}">
                <a16:creationId xmlns:a16="http://schemas.microsoft.com/office/drawing/2014/main" id="{25AB965F-979B-DC28-C824-DFC9EB5CAAC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4078" y="3332405"/>
            <a:ext cx="2971006" cy="2376805"/>
          </a:xfrm>
          <a:prstGeom prst="rect">
            <a:avLst/>
          </a:prstGeom>
        </p:spPr>
      </p:pic>
      <p:pic>
        <p:nvPicPr>
          <p:cNvPr id="16" name="图片 15" descr="图形用户界面, 应用程序&#10;&#10;描述已自动生成">
            <a:extLst>
              <a:ext uri="{FF2B5EF4-FFF2-40B4-BE49-F238E27FC236}">
                <a16:creationId xmlns:a16="http://schemas.microsoft.com/office/drawing/2014/main" id="{88F8CBA9-BCB9-A8AC-308D-8BDEDF1023F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12279" y="705886"/>
            <a:ext cx="2971006" cy="2376805"/>
          </a:xfrm>
          <a:prstGeom prst="rect">
            <a:avLst/>
          </a:prstGeom>
        </p:spPr>
      </p:pic>
      <p:pic>
        <p:nvPicPr>
          <p:cNvPr id="18" name="图片 17" descr="图形用户界面, 应用程序&#10;&#10;描述已自动生成">
            <a:extLst>
              <a:ext uri="{FF2B5EF4-FFF2-40B4-BE49-F238E27FC236}">
                <a16:creationId xmlns:a16="http://schemas.microsoft.com/office/drawing/2014/main" id="{5B80552A-266A-E0EB-A076-175B8712383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4078" y="705886"/>
            <a:ext cx="2971006" cy="2376805"/>
          </a:xfrm>
          <a:prstGeom prst="rect">
            <a:avLst/>
          </a:prstGeom>
        </p:spPr>
      </p:pic>
      <p:pic>
        <p:nvPicPr>
          <p:cNvPr id="20" name="图片 19" descr="图形用户界面, 应用程序, PowerPoint&#10;&#10;描述已自动生成">
            <a:extLst>
              <a:ext uri="{FF2B5EF4-FFF2-40B4-BE49-F238E27FC236}">
                <a16:creationId xmlns:a16="http://schemas.microsoft.com/office/drawing/2014/main" id="{BFF659B6-A011-7D04-A00A-AC3675EF03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12279" y="5958925"/>
            <a:ext cx="2971007" cy="237680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F3087B2-DBF6-BB4F-F25C-0B62FC127DE1}"/>
              </a:ext>
            </a:extLst>
          </p:cNvPr>
          <p:cNvSpPr txBox="1"/>
          <p:nvPr/>
        </p:nvSpPr>
        <p:spPr>
          <a:xfrm>
            <a:off x="108886" y="8428672"/>
            <a:ext cx="655059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" altLang="zh-CN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UMAP visualization depicting regulon activity for selected key regulons, related to Figure 5. Regulon activity is represented by AUC values, with darker colors indicating higher activity levels.</a:t>
            </a:r>
          </a:p>
        </p:txBody>
      </p:sp>
    </p:spTree>
    <p:extLst>
      <p:ext uri="{BB962C8B-B14F-4D97-AF65-F5344CB8AC3E}">
        <p14:creationId xmlns:p14="http://schemas.microsoft.com/office/powerpoint/2010/main" val="29769558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1906F06-18EB-5640-782C-D1BDC24CF039}"/>
              </a:ext>
            </a:extLst>
          </p:cNvPr>
          <p:cNvSpPr txBox="1"/>
          <p:nvPr/>
        </p:nvSpPr>
        <p:spPr>
          <a:xfrm>
            <a:off x="1209519" y="2847448"/>
            <a:ext cx="12506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Major EGA down</a:t>
            </a:r>
            <a:endParaRPr kumimoji="1" lang="zh-CN" altLang="en-US" sz="1100" dirty="0">
              <a:latin typeface="Helvetica" pitchFamily="2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2DFF016-C66A-DB72-DD2D-F45755C209CB}"/>
              </a:ext>
            </a:extLst>
          </p:cNvPr>
          <p:cNvSpPr txBox="1"/>
          <p:nvPr/>
        </p:nvSpPr>
        <p:spPr>
          <a:xfrm>
            <a:off x="1209519" y="360130"/>
            <a:ext cx="125066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Minor EGA down</a:t>
            </a:r>
            <a:endParaRPr kumimoji="1" lang="zh-CN" altLang="en-US" sz="1100" dirty="0">
              <a:latin typeface="Helvetica" pitchFamily="2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ADB8A5C-66A0-CDF8-227D-E8636C185137}"/>
              </a:ext>
            </a:extLst>
          </p:cNvPr>
          <p:cNvSpPr txBox="1"/>
          <p:nvPr/>
        </p:nvSpPr>
        <p:spPr>
          <a:xfrm>
            <a:off x="4742463" y="4713129"/>
            <a:ext cx="5613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TE up</a:t>
            </a:r>
            <a:endParaRPr kumimoji="1" lang="zh-CN" altLang="en-US" sz="1100" dirty="0">
              <a:latin typeface="Helvetica" pitchFamily="2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DDC629D-81D5-A2CE-084B-668A27E96833}"/>
              </a:ext>
            </a:extLst>
          </p:cNvPr>
          <p:cNvSpPr txBox="1"/>
          <p:nvPr/>
        </p:nvSpPr>
        <p:spPr>
          <a:xfrm>
            <a:off x="4488387" y="2852283"/>
            <a:ext cx="10695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Major EGA up</a:t>
            </a:r>
            <a:endParaRPr kumimoji="1" lang="zh-CN" altLang="en-US" sz="1100" dirty="0">
              <a:latin typeface="Helvetica" pitchFamily="2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E4B57A4-D9F6-2AFF-B0B7-89E3DC7ADCA3}"/>
              </a:ext>
            </a:extLst>
          </p:cNvPr>
          <p:cNvSpPr txBox="1"/>
          <p:nvPr/>
        </p:nvSpPr>
        <p:spPr>
          <a:xfrm>
            <a:off x="4488387" y="360130"/>
            <a:ext cx="10695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Minor EGA up</a:t>
            </a:r>
            <a:endParaRPr kumimoji="1" lang="zh-CN" altLang="en-US" sz="1100" dirty="0">
              <a:latin typeface="Helvetica" pitchFamily="2" charset="0"/>
            </a:endParaRPr>
          </a:p>
        </p:txBody>
      </p:sp>
      <p:pic>
        <p:nvPicPr>
          <p:cNvPr id="8" name="图片 7" descr="图示, 维恩图&#10;&#10;描述已自动生成">
            <a:extLst>
              <a:ext uri="{FF2B5EF4-FFF2-40B4-BE49-F238E27FC236}">
                <a16:creationId xmlns:a16="http://schemas.microsoft.com/office/drawing/2014/main" id="{9F3DAC96-4CD1-956C-C4EA-FC753933D8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732" y="621740"/>
            <a:ext cx="1840237" cy="2066368"/>
          </a:xfrm>
          <a:prstGeom prst="rect">
            <a:avLst/>
          </a:prstGeom>
        </p:spPr>
      </p:pic>
      <p:pic>
        <p:nvPicPr>
          <p:cNvPr id="13" name="图片 12" descr="图示, 维恩图&#10;&#10;描述已自动生成">
            <a:extLst>
              <a:ext uri="{FF2B5EF4-FFF2-40B4-BE49-F238E27FC236}">
                <a16:creationId xmlns:a16="http://schemas.microsoft.com/office/drawing/2014/main" id="{E6198D88-8749-830D-0904-C025CF92FB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3031" y="621740"/>
            <a:ext cx="1840237" cy="2066368"/>
          </a:xfrm>
          <a:prstGeom prst="rect">
            <a:avLst/>
          </a:prstGeom>
        </p:spPr>
      </p:pic>
      <p:pic>
        <p:nvPicPr>
          <p:cNvPr id="17" name="图片 16" descr="图表, 图示, 饼图&#10;&#10;描述已自动生成">
            <a:extLst>
              <a:ext uri="{FF2B5EF4-FFF2-40B4-BE49-F238E27FC236}">
                <a16:creationId xmlns:a16="http://schemas.microsoft.com/office/drawing/2014/main" id="{66B4217C-108E-4881-0AA8-23A6A4032BA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9534" b="28326"/>
          <a:stretch/>
        </p:blipFill>
        <p:spPr>
          <a:xfrm>
            <a:off x="408773" y="3109058"/>
            <a:ext cx="2852155" cy="1500711"/>
          </a:xfrm>
          <a:prstGeom prst="rect">
            <a:avLst/>
          </a:prstGeom>
        </p:spPr>
      </p:pic>
      <p:pic>
        <p:nvPicPr>
          <p:cNvPr id="26" name="图片 25" descr="图表, 图示, 饼图&#10;&#10;描述已自动生成">
            <a:extLst>
              <a:ext uri="{FF2B5EF4-FFF2-40B4-BE49-F238E27FC236}">
                <a16:creationId xmlns:a16="http://schemas.microsoft.com/office/drawing/2014/main" id="{DEF457F7-6A47-B8CE-23FA-8226027E38C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9534" b="28325"/>
          <a:stretch/>
        </p:blipFill>
        <p:spPr>
          <a:xfrm>
            <a:off x="3597072" y="3109057"/>
            <a:ext cx="2852155" cy="1500711"/>
          </a:xfrm>
          <a:prstGeom prst="rect">
            <a:avLst/>
          </a:prstGeom>
        </p:spPr>
      </p:pic>
      <p:pic>
        <p:nvPicPr>
          <p:cNvPr id="28" name="图片 27" descr="图示, 维恩图&#10;&#10;描述已自动生成">
            <a:extLst>
              <a:ext uri="{FF2B5EF4-FFF2-40B4-BE49-F238E27FC236}">
                <a16:creationId xmlns:a16="http://schemas.microsoft.com/office/drawing/2014/main" id="{B6F82CC9-0E99-6509-E4D5-E846FB77BB0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18978" b="19164"/>
          <a:stretch/>
        </p:blipFill>
        <p:spPr>
          <a:xfrm>
            <a:off x="4210855" y="4953000"/>
            <a:ext cx="1624588" cy="1726908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75B6C0AE-ECA9-3332-A6E2-BAF10EDB530A}"/>
              </a:ext>
            </a:extLst>
          </p:cNvPr>
          <p:cNvSpPr txBox="1"/>
          <p:nvPr/>
        </p:nvSpPr>
        <p:spPr>
          <a:xfrm>
            <a:off x="1463595" y="4691390"/>
            <a:ext cx="7425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100" dirty="0">
                <a:latin typeface="Helvetica" pitchFamily="2" charset="0"/>
              </a:rPr>
              <a:t>TE down</a:t>
            </a:r>
            <a:endParaRPr kumimoji="1" lang="zh-CN" altLang="en-US" sz="1100" dirty="0">
              <a:latin typeface="Helvetica" pitchFamily="2" charset="0"/>
            </a:endParaRPr>
          </a:p>
        </p:txBody>
      </p:sp>
      <p:pic>
        <p:nvPicPr>
          <p:cNvPr id="31" name="图片 30" descr="图示, 维恩图&#10;&#10;描述已自动生成">
            <a:extLst>
              <a:ext uri="{FF2B5EF4-FFF2-40B4-BE49-F238E27FC236}">
                <a16:creationId xmlns:a16="http://schemas.microsoft.com/office/drawing/2014/main" id="{77F19C0B-80BF-DA5E-B80A-916128A7DF9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8978" b="19164"/>
          <a:stretch/>
        </p:blipFill>
        <p:spPr>
          <a:xfrm>
            <a:off x="1022556" y="4953000"/>
            <a:ext cx="1624588" cy="172690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258F476-5618-8624-9F10-2CB238FEFAD7}"/>
              </a:ext>
            </a:extLst>
          </p:cNvPr>
          <p:cNvSpPr txBox="1"/>
          <p:nvPr/>
        </p:nvSpPr>
        <p:spPr>
          <a:xfrm>
            <a:off x="280001" y="6975732"/>
            <a:ext cx="629990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" altLang="zh-CN" sz="10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r>
              <a:rPr lang="en" altLang="zh-CN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. Venn diagram illustrating the upregulated (Up) or downregulated (Down) genes in androgenetic, gynogenetic, polyploid, and all combined WG-aberrant cells compared to biparental diploid cells across different molecular developmental stages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872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4</TotalTime>
  <Words>254</Words>
  <Application>Microsoft Macintosh PowerPoint</Application>
  <PresentationFormat>A4 纸张(210x297 毫米)</PresentationFormat>
  <Paragraphs>15</Paragraphs>
  <Slides>6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Helvetica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 Zhao</dc:creator>
  <cp:lastModifiedBy>Yan Zhao</cp:lastModifiedBy>
  <cp:revision>1</cp:revision>
  <dcterms:created xsi:type="dcterms:W3CDTF">2024-05-02T12:34:13Z</dcterms:created>
  <dcterms:modified xsi:type="dcterms:W3CDTF">2024-07-30T14:13:37Z</dcterms:modified>
</cp:coreProperties>
</file>